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7"/>
  </p:notesMasterIdLst>
  <p:sldIdLst>
    <p:sldId id="266" r:id="rId2"/>
    <p:sldId id="267" r:id="rId3"/>
    <p:sldId id="268" r:id="rId4"/>
    <p:sldId id="271" r:id="rId5"/>
    <p:sldId id="27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5AD8C16-32DE-4D78-BCED-EED2AB8F2B8C}" v="14" dt="2023-06-29T09:30:23.47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9631B5-78F2-41C9-869B-9F39066F8104}" styleName="Stile medio 3 - Colore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131" autoAdjust="0"/>
  </p:normalViewPr>
  <p:slideViewPr>
    <p:cSldViewPr snapToGrid="0">
      <p:cViewPr varScale="1">
        <p:scale>
          <a:sx n="52" d="100"/>
          <a:sy n="52" d="100"/>
        </p:scale>
        <p:origin x="271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LO D'AVINO" userId="712f3eeb-80c4-4bbb-832e-61fb1f039a14" providerId="ADAL" clId="{89323929-7422-4CF9-9D8A-BF567E660A8D}"/>
    <pc:docChg chg="undo custSel modSld">
      <pc:chgData name="DANILO D'AVINO" userId="712f3eeb-80c4-4bbb-832e-61fb1f039a14" providerId="ADAL" clId="{89323929-7422-4CF9-9D8A-BF567E660A8D}" dt="2023-06-28T10:48:56.763" v="5" actId="5793"/>
      <pc:docMkLst>
        <pc:docMk/>
      </pc:docMkLst>
      <pc:sldChg chg="modSp mod">
        <pc:chgData name="DANILO D'AVINO" userId="712f3eeb-80c4-4bbb-832e-61fb1f039a14" providerId="ADAL" clId="{89323929-7422-4CF9-9D8A-BF567E660A8D}" dt="2023-06-28T10:48:56.763" v="5" actId="5793"/>
        <pc:sldMkLst>
          <pc:docMk/>
          <pc:sldMk cId="1529194074" sldId="266"/>
        </pc:sldMkLst>
        <pc:spChg chg="mod">
          <ac:chgData name="DANILO D'AVINO" userId="712f3eeb-80c4-4bbb-832e-61fb1f039a14" providerId="ADAL" clId="{89323929-7422-4CF9-9D8A-BF567E660A8D}" dt="2023-06-28T10:48:56.763" v="5" actId="5793"/>
          <ac:spMkLst>
            <pc:docMk/>
            <pc:sldMk cId="1529194074" sldId="266"/>
            <ac:spMk id="235" creationId="{C83461EB-417D-AF08-525B-CFF67AA224B2}"/>
          </ac:spMkLst>
        </pc:spChg>
      </pc:sldChg>
    </pc:docChg>
  </pc:docChgLst>
  <pc:docChgLst>
    <pc:chgData name="DANILO D'AVINO" userId="0e6c6f40-5f9d-4050-8a90-1a705275c850" providerId="ADAL" clId="{E5AD8C16-32DE-4D78-BCED-EED2AB8F2B8C}"/>
    <pc:docChg chg="custSel addSld modSld">
      <pc:chgData name="DANILO D'AVINO" userId="0e6c6f40-5f9d-4050-8a90-1a705275c850" providerId="ADAL" clId="{E5AD8C16-32DE-4D78-BCED-EED2AB8F2B8C}" dt="2023-06-28T19:27:02.035" v="13" actId="478"/>
      <pc:docMkLst>
        <pc:docMk/>
      </pc:docMkLst>
      <pc:sldChg chg="addSp delSp modSp new mod">
        <pc:chgData name="DANILO D'AVINO" userId="0e6c6f40-5f9d-4050-8a90-1a705275c850" providerId="ADAL" clId="{E5AD8C16-32DE-4D78-BCED-EED2AB8F2B8C}" dt="2023-06-28T19:27:02.035" v="13" actId="478"/>
        <pc:sldMkLst>
          <pc:docMk/>
          <pc:sldMk cId="2035222781" sldId="267"/>
        </pc:sldMkLst>
        <pc:graphicFrameChg chg="add del mod modGraphic">
          <ac:chgData name="DANILO D'AVINO" userId="0e6c6f40-5f9d-4050-8a90-1a705275c850" providerId="ADAL" clId="{E5AD8C16-32DE-4D78-BCED-EED2AB8F2B8C}" dt="2023-06-28T19:25:12.873" v="6" actId="478"/>
          <ac:graphicFrameMkLst>
            <pc:docMk/>
            <pc:sldMk cId="2035222781" sldId="267"/>
            <ac:graphicFrameMk id="2" creationId="{589E1DE8-DB5F-7FBA-EFC3-6ED30148E96D}"/>
          </ac:graphicFrameMkLst>
        </pc:graphicFrameChg>
        <pc:graphicFrameChg chg="add del mod modGraphic">
          <ac:chgData name="DANILO D'AVINO" userId="0e6c6f40-5f9d-4050-8a90-1a705275c850" providerId="ADAL" clId="{E5AD8C16-32DE-4D78-BCED-EED2AB8F2B8C}" dt="2023-06-28T19:27:02.035" v="13" actId="478"/>
          <ac:graphicFrameMkLst>
            <pc:docMk/>
            <pc:sldMk cId="2035222781" sldId="267"/>
            <ac:graphicFrameMk id="3" creationId="{F4EE29D2-571E-08E6-30FB-6C021A4B9915}"/>
          </ac:graphicFrameMkLst>
        </pc:graphicFrameChg>
      </pc:sldChg>
    </pc:docChg>
  </pc:docChgLst>
  <pc:docChgLst>
    <pc:chgData name="DANILO D'AVINO" userId="712f3eeb-80c4-4bbb-832e-61fb1f039a14" providerId="ADAL" clId="{E5AD8C16-32DE-4D78-BCED-EED2AB8F2B8C}"/>
    <pc:docChg chg="undo custSel addSld delSld modSld sldOrd">
      <pc:chgData name="DANILO D'AVINO" userId="712f3eeb-80c4-4bbb-832e-61fb1f039a14" providerId="ADAL" clId="{E5AD8C16-32DE-4D78-BCED-EED2AB8F2B8C}" dt="2023-06-29T09:30:49.980" v="125" actId="20577"/>
      <pc:docMkLst>
        <pc:docMk/>
      </pc:docMkLst>
      <pc:sldChg chg="addSp delSp modSp mod">
        <pc:chgData name="DANILO D'AVINO" userId="712f3eeb-80c4-4bbb-832e-61fb1f039a14" providerId="ADAL" clId="{E5AD8C16-32DE-4D78-BCED-EED2AB8F2B8C}" dt="2023-06-29T09:12:20.871" v="60" actId="20577"/>
        <pc:sldMkLst>
          <pc:docMk/>
          <pc:sldMk cId="2035222781" sldId="267"/>
        </pc:sldMkLst>
        <pc:spChg chg="add mod">
          <ac:chgData name="DANILO D'AVINO" userId="712f3eeb-80c4-4bbb-832e-61fb1f039a14" providerId="ADAL" clId="{E5AD8C16-32DE-4D78-BCED-EED2AB8F2B8C}" dt="2023-06-29T09:12:20.871" v="60" actId="20577"/>
          <ac:spMkLst>
            <pc:docMk/>
            <pc:sldMk cId="2035222781" sldId="267"/>
            <ac:spMk id="2" creationId="{7DE41A81-3352-ABF8-B686-00766E325661}"/>
          </ac:spMkLst>
        </pc:spChg>
        <pc:graphicFrameChg chg="add del mod">
          <ac:chgData name="DANILO D'AVINO" userId="712f3eeb-80c4-4bbb-832e-61fb1f039a14" providerId="ADAL" clId="{E5AD8C16-32DE-4D78-BCED-EED2AB8F2B8C}" dt="2023-06-29T07:42:23.787" v="2" actId="478"/>
          <ac:graphicFrameMkLst>
            <pc:docMk/>
            <pc:sldMk cId="2035222781" sldId="267"/>
            <ac:graphicFrameMk id="2" creationId="{E06145B4-8F48-6B9E-5A54-51D3D3D21DFC}"/>
          </ac:graphicFrameMkLst>
        </pc:graphicFrameChg>
        <pc:graphicFrameChg chg="add del mod">
          <ac:chgData name="DANILO D'AVINO" userId="712f3eeb-80c4-4bbb-832e-61fb1f039a14" providerId="ADAL" clId="{E5AD8C16-32DE-4D78-BCED-EED2AB8F2B8C}" dt="2023-06-29T07:42:39.853" v="4" actId="478"/>
          <ac:graphicFrameMkLst>
            <pc:docMk/>
            <pc:sldMk cId="2035222781" sldId="267"/>
            <ac:graphicFrameMk id="3" creationId="{6394E0F9-B5B1-BA5E-DB6A-491E17001828}"/>
          </ac:graphicFrameMkLst>
        </pc:graphicFrameChg>
        <pc:graphicFrameChg chg="add mod modGraphic">
          <ac:chgData name="DANILO D'AVINO" userId="712f3eeb-80c4-4bbb-832e-61fb1f039a14" providerId="ADAL" clId="{E5AD8C16-32DE-4D78-BCED-EED2AB8F2B8C}" dt="2023-06-29T07:42:47.239" v="7" actId="1076"/>
          <ac:graphicFrameMkLst>
            <pc:docMk/>
            <pc:sldMk cId="2035222781" sldId="267"/>
            <ac:graphicFrameMk id="4" creationId="{66C6EF5D-37A9-C337-416B-DBE2BB0563F8}"/>
          </ac:graphicFrameMkLst>
        </pc:graphicFrameChg>
      </pc:sldChg>
      <pc:sldChg chg="addSp delSp modSp add mod">
        <pc:chgData name="DANILO D'AVINO" userId="712f3eeb-80c4-4bbb-832e-61fb1f039a14" providerId="ADAL" clId="{E5AD8C16-32DE-4D78-BCED-EED2AB8F2B8C}" dt="2023-06-29T09:16:58.767" v="115" actId="20577"/>
        <pc:sldMkLst>
          <pc:docMk/>
          <pc:sldMk cId="1902948419" sldId="268"/>
        </pc:sldMkLst>
        <pc:spChg chg="mod">
          <ac:chgData name="DANILO D'AVINO" userId="712f3eeb-80c4-4bbb-832e-61fb1f039a14" providerId="ADAL" clId="{E5AD8C16-32DE-4D78-BCED-EED2AB8F2B8C}" dt="2023-06-29T09:15:02.565" v="79"/>
          <ac:spMkLst>
            <pc:docMk/>
            <pc:sldMk cId="1902948419" sldId="268"/>
            <ac:spMk id="2" creationId="{7DE41A81-3352-ABF8-B686-00766E325661}"/>
          </ac:spMkLst>
        </pc:spChg>
        <pc:graphicFrameChg chg="add del mod">
          <ac:chgData name="DANILO D'AVINO" userId="712f3eeb-80c4-4bbb-832e-61fb1f039a14" providerId="ADAL" clId="{E5AD8C16-32DE-4D78-BCED-EED2AB8F2B8C}" dt="2023-06-29T09:08:00.576" v="23"/>
          <ac:graphicFrameMkLst>
            <pc:docMk/>
            <pc:sldMk cId="1902948419" sldId="268"/>
            <ac:graphicFrameMk id="3" creationId="{788DC82E-EC93-B66C-FC65-6C60C69A27E5}"/>
          </ac:graphicFrameMkLst>
        </pc:graphicFrameChg>
        <pc:graphicFrameChg chg="del">
          <ac:chgData name="DANILO D'AVINO" userId="712f3eeb-80c4-4bbb-832e-61fb1f039a14" providerId="ADAL" clId="{E5AD8C16-32DE-4D78-BCED-EED2AB8F2B8C}" dt="2023-06-29T09:07:56.205" v="21" actId="478"/>
          <ac:graphicFrameMkLst>
            <pc:docMk/>
            <pc:sldMk cId="1902948419" sldId="268"/>
            <ac:graphicFrameMk id="4" creationId="{66C6EF5D-37A9-C337-416B-DBE2BB0563F8}"/>
          </ac:graphicFrameMkLst>
        </pc:graphicFrameChg>
        <pc:graphicFrameChg chg="add mod modGraphic">
          <ac:chgData name="DANILO D'AVINO" userId="712f3eeb-80c4-4bbb-832e-61fb1f039a14" providerId="ADAL" clId="{E5AD8C16-32DE-4D78-BCED-EED2AB8F2B8C}" dt="2023-06-29T09:16:58.767" v="115" actId="20577"/>
          <ac:graphicFrameMkLst>
            <pc:docMk/>
            <pc:sldMk cId="1902948419" sldId="268"/>
            <ac:graphicFrameMk id="5" creationId="{8BC511E1-A7D7-6892-9D5E-165D97D164A1}"/>
          </ac:graphicFrameMkLst>
        </pc:graphicFrameChg>
        <pc:graphicFrameChg chg="add mod modGraphic">
          <ac:chgData name="DANILO D'AVINO" userId="712f3eeb-80c4-4bbb-832e-61fb1f039a14" providerId="ADAL" clId="{E5AD8C16-32DE-4D78-BCED-EED2AB8F2B8C}" dt="2023-06-29T09:09:14.325" v="35" actId="14100"/>
          <ac:graphicFrameMkLst>
            <pc:docMk/>
            <pc:sldMk cId="1902948419" sldId="268"/>
            <ac:graphicFrameMk id="6" creationId="{8B234807-1476-9EF7-4617-95E56BB2F28D}"/>
          </ac:graphicFrameMkLst>
        </pc:graphicFrameChg>
      </pc:sldChg>
      <pc:sldChg chg="add del ord">
        <pc:chgData name="DANILO D'AVINO" userId="712f3eeb-80c4-4bbb-832e-61fb1f039a14" providerId="ADAL" clId="{E5AD8C16-32DE-4D78-BCED-EED2AB8F2B8C}" dt="2023-06-29T09:13:42.269" v="65" actId="47"/>
        <pc:sldMkLst>
          <pc:docMk/>
          <pc:sldMk cId="2834181041" sldId="269"/>
        </pc:sldMkLst>
      </pc:sldChg>
      <pc:sldChg chg="addSp delSp modSp add del mod">
        <pc:chgData name="DANILO D'AVINO" userId="712f3eeb-80c4-4bbb-832e-61fb1f039a14" providerId="ADAL" clId="{E5AD8C16-32DE-4D78-BCED-EED2AB8F2B8C}" dt="2023-06-29T09:15:21.297" v="85" actId="47"/>
        <pc:sldMkLst>
          <pc:docMk/>
          <pc:sldMk cId="790782774" sldId="270"/>
        </pc:sldMkLst>
        <pc:spChg chg="mod">
          <ac:chgData name="DANILO D'AVINO" userId="712f3eeb-80c4-4bbb-832e-61fb1f039a14" providerId="ADAL" clId="{E5AD8C16-32DE-4D78-BCED-EED2AB8F2B8C}" dt="2023-06-29T09:15:08.954" v="83" actId="20577"/>
          <ac:spMkLst>
            <pc:docMk/>
            <pc:sldMk cId="790782774" sldId="270"/>
            <ac:spMk id="2" creationId="{7DE41A81-3352-ABF8-B686-00766E325661}"/>
          </ac:spMkLst>
        </pc:spChg>
        <pc:graphicFrameChg chg="add mod modGraphic">
          <ac:chgData name="DANILO D'AVINO" userId="712f3eeb-80c4-4bbb-832e-61fb1f039a14" providerId="ADAL" clId="{E5AD8C16-32DE-4D78-BCED-EED2AB8F2B8C}" dt="2023-06-29T09:14:47.566" v="77" actId="14100"/>
          <ac:graphicFrameMkLst>
            <pc:docMk/>
            <pc:sldMk cId="790782774" sldId="270"/>
            <ac:graphicFrameMk id="3" creationId="{755209D6-9CB7-D7FC-9260-B63AA9424933}"/>
          </ac:graphicFrameMkLst>
        </pc:graphicFrameChg>
        <pc:graphicFrameChg chg="del">
          <ac:chgData name="DANILO D'AVINO" userId="712f3eeb-80c4-4bbb-832e-61fb1f039a14" providerId="ADAL" clId="{E5AD8C16-32DE-4D78-BCED-EED2AB8F2B8C}" dt="2023-06-29T09:13:54.214" v="66" actId="478"/>
          <ac:graphicFrameMkLst>
            <pc:docMk/>
            <pc:sldMk cId="790782774" sldId="270"/>
            <ac:graphicFrameMk id="5" creationId="{8BC511E1-A7D7-6892-9D5E-165D97D164A1}"/>
          </ac:graphicFrameMkLst>
        </pc:graphicFrameChg>
      </pc:sldChg>
      <pc:sldChg chg="add">
        <pc:chgData name="DANILO D'AVINO" userId="712f3eeb-80c4-4bbb-832e-61fb1f039a14" providerId="ADAL" clId="{E5AD8C16-32DE-4D78-BCED-EED2AB8F2B8C}" dt="2023-06-29T09:15:12.310" v="84" actId="2890"/>
        <pc:sldMkLst>
          <pc:docMk/>
          <pc:sldMk cId="96513451" sldId="271"/>
        </pc:sldMkLst>
      </pc:sldChg>
      <pc:sldChg chg="addSp delSp modSp add mod">
        <pc:chgData name="DANILO D'AVINO" userId="712f3eeb-80c4-4bbb-832e-61fb1f039a14" providerId="ADAL" clId="{E5AD8C16-32DE-4D78-BCED-EED2AB8F2B8C}" dt="2023-06-29T09:30:49.980" v="125" actId="20577"/>
        <pc:sldMkLst>
          <pc:docMk/>
          <pc:sldMk cId="2100116566" sldId="272"/>
        </pc:sldMkLst>
        <pc:spChg chg="mod">
          <ac:chgData name="DANILO D'AVINO" userId="712f3eeb-80c4-4bbb-832e-61fb1f039a14" providerId="ADAL" clId="{E5AD8C16-32DE-4D78-BCED-EED2AB8F2B8C}" dt="2023-06-29T09:30:49.980" v="125" actId="20577"/>
          <ac:spMkLst>
            <pc:docMk/>
            <pc:sldMk cId="2100116566" sldId="272"/>
            <ac:spMk id="2" creationId="{7DE41A81-3352-ABF8-B686-00766E325661}"/>
          </ac:spMkLst>
        </pc:spChg>
        <pc:graphicFrameChg chg="del">
          <ac:chgData name="DANILO D'AVINO" userId="712f3eeb-80c4-4bbb-832e-61fb1f039a14" providerId="ADAL" clId="{E5AD8C16-32DE-4D78-BCED-EED2AB8F2B8C}" dt="2023-06-29T09:30:21.983" v="117" actId="478"/>
          <ac:graphicFrameMkLst>
            <pc:docMk/>
            <pc:sldMk cId="2100116566" sldId="272"/>
            <ac:graphicFrameMk id="3" creationId="{755209D6-9CB7-D7FC-9260-B63AA9424933}"/>
          </ac:graphicFrameMkLst>
        </pc:graphicFrameChg>
        <pc:graphicFrameChg chg="add mod modGraphic">
          <ac:chgData name="DANILO D'AVINO" userId="712f3eeb-80c4-4bbb-832e-61fb1f039a14" providerId="ADAL" clId="{E5AD8C16-32DE-4D78-BCED-EED2AB8F2B8C}" dt="2023-06-29T09:30:44.502" v="123" actId="14100"/>
          <ac:graphicFrameMkLst>
            <pc:docMk/>
            <pc:sldMk cId="2100116566" sldId="272"/>
            <ac:graphicFrameMk id="4" creationId="{64C9C852-88E7-D8F3-4707-3D340E6EC829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59C1A3-0D19-4149-8085-7E49B3A62324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9EFF08-AA49-47E0-958F-D15FE68EE10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7399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9EFF08-AA49-47E0-958F-D15FE68EE109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00216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12145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5225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4856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1220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6401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2996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3281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8988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385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4730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2833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1DA91-0658-4A09-A55F-2A3EFD3E4A88}" type="datetimeFigureOut">
              <a:rPr lang="it-IT" smtClean="0"/>
              <a:t>2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66EA3-4E5B-45D6-8E58-3060189847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7069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1" name="Gruppo 230">
            <a:extLst>
              <a:ext uri="{FF2B5EF4-FFF2-40B4-BE49-F238E27FC236}">
                <a16:creationId xmlns:a16="http://schemas.microsoft.com/office/drawing/2014/main" id="{2145B3BC-EB37-EAAF-5825-3C8BEE06E5D2}"/>
              </a:ext>
            </a:extLst>
          </p:cNvPr>
          <p:cNvGrpSpPr/>
          <p:nvPr/>
        </p:nvGrpSpPr>
        <p:grpSpPr>
          <a:xfrm>
            <a:off x="298903" y="5004667"/>
            <a:ext cx="5375053" cy="2147675"/>
            <a:chOff x="348388" y="2667338"/>
            <a:chExt cx="5375053" cy="2147675"/>
          </a:xfrm>
        </p:grpSpPr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77B2F276-A3B7-DA67-7DED-84B5A74D6CBF}"/>
                </a:ext>
              </a:extLst>
            </p:cNvPr>
            <p:cNvSpPr txBox="1"/>
            <p:nvPr/>
          </p:nvSpPr>
          <p:spPr>
            <a:xfrm>
              <a:off x="348388" y="3646117"/>
              <a:ext cx="799329" cy="475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46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sz="1246" b="1" dirty="0">
                  <a:latin typeface="Arial" panose="020B0604020202020204" pitchFamily="34" charset="0"/>
                  <a:cs typeface="Arial" panose="020B0604020202020204" pitchFamily="34" charset="0"/>
                </a:rPr>
                <a:t>-actin  </a:t>
              </a:r>
            </a:p>
            <a:p>
              <a:pPr algn="ctr"/>
              <a:r>
                <a:rPr lang="it-IT" sz="1246" b="1" dirty="0">
                  <a:latin typeface="Arial" panose="020B0604020202020204" pitchFamily="34" charset="0"/>
                  <a:cs typeface="Arial" panose="020B0604020202020204" pitchFamily="34" charset="0"/>
                </a:rPr>
                <a:t>(45 </a:t>
              </a:r>
              <a:r>
                <a:rPr lang="it-IT" sz="1246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it-IT" sz="1246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pic>
          <p:nvPicPr>
            <p:cNvPr id="3" name="Immagine 2" descr="Immagine che contiene Rettangolo, bianco e nero, Fotografia monocromatica, monocromatico&#10;&#10;Descrizione generata automaticamente">
              <a:extLst>
                <a:ext uri="{FF2B5EF4-FFF2-40B4-BE49-F238E27FC236}">
                  <a16:creationId xmlns:a16="http://schemas.microsoft.com/office/drawing/2014/main" id="{1B54B42E-1B58-23AF-60F0-EAAF9A09BE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80" t="33367" r="42901" b="39999"/>
            <a:stretch/>
          </p:blipFill>
          <p:spPr>
            <a:xfrm>
              <a:off x="1474170" y="3051013"/>
              <a:ext cx="1889186" cy="1764000"/>
            </a:xfrm>
            <a:prstGeom prst="rect">
              <a:avLst/>
            </a:prstGeom>
          </p:spPr>
        </p:pic>
        <p:pic>
          <p:nvPicPr>
            <p:cNvPr id="4" name="Immagine 3" descr="Immagine che contiene nebbia, bianco e nero, Fotografia monocromatica, monocromatico&#10;&#10;Descrizione generata automaticamente">
              <a:extLst>
                <a:ext uri="{FF2B5EF4-FFF2-40B4-BE49-F238E27FC236}">
                  <a16:creationId xmlns:a16="http://schemas.microsoft.com/office/drawing/2014/main" id="{C6A3264A-7551-3B69-1A2E-0E8BF0517B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87" t="29446" r="42906" b="45954"/>
            <a:stretch/>
          </p:blipFill>
          <p:spPr>
            <a:xfrm>
              <a:off x="3594444" y="3043993"/>
              <a:ext cx="2017383" cy="1764000"/>
            </a:xfrm>
            <a:prstGeom prst="rect">
              <a:avLst/>
            </a:prstGeom>
          </p:spPr>
        </p:pic>
        <p:sp>
          <p:nvSpPr>
            <p:cNvPr id="80" name="Rettangolo 79">
              <a:extLst>
                <a:ext uri="{FF2B5EF4-FFF2-40B4-BE49-F238E27FC236}">
                  <a16:creationId xmlns:a16="http://schemas.microsoft.com/office/drawing/2014/main" id="{2367548E-B15D-58D0-2DFE-61BC6FF5EBE4}"/>
                </a:ext>
              </a:extLst>
            </p:cNvPr>
            <p:cNvSpPr/>
            <p:nvPr/>
          </p:nvSpPr>
          <p:spPr>
            <a:xfrm>
              <a:off x="1724096" y="3846501"/>
              <a:ext cx="1639260" cy="35855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701"/>
            </a:p>
          </p:txBody>
        </p:sp>
        <p:grpSp>
          <p:nvGrpSpPr>
            <p:cNvPr id="176" name="Gruppo 175">
              <a:extLst>
                <a:ext uri="{FF2B5EF4-FFF2-40B4-BE49-F238E27FC236}">
                  <a16:creationId xmlns:a16="http://schemas.microsoft.com/office/drawing/2014/main" id="{C2425B70-33B1-8620-5EA5-D38B16A78C76}"/>
                </a:ext>
              </a:extLst>
            </p:cNvPr>
            <p:cNvGrpSpPr/>
            <p:nvPr/>
          </p:nvGrpSpPr>
          <p:grpSpPr>
            <a:xfrm>
              <a:off x="1089361" y="3008708"/>
              <a:ext cx="437018" cy="1589909"/>
              <a:chOff x="843064" y="3300228"/>
              <a:chExt cx="437018" cy="1589909"/>
            </a:xfrm>
          </p:grpSpPr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82CC3E50-6242-77DA-9BF5-63AFE0AA8174}"/>
                  </a:ext>
                </a:extLst>
              </p:cNvPr>
              <p:cNvSpPr txBox="1"/>
              <p:nvPr/>
            </p:nvSpPr>
            <p:spPr>
              <a:xfrm>
                <a:off x="868780" y="3442601"/>
                <a:ext cx="3998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89" name="CasellaDiTesto 88">
                <a:extLst>
                  <a:ext uri="{FF2B5EF4-FFF2-40B4-BE49-F238E27FC236}">
                    <a16:creationId xmlns:a16="http://schemas.microsoft.com/office/drawing/2014/main" id="{F35A81FA-6F08-EF24-8733-16FA554B58BA}"/>
                  </a:ext>
                </a:extLst>
              </p:cNvPr>
              <p:cNvSpPr txBox="1"/>
              <p:nvPr/>
            </p:nvSpPr>
            <p:spPr>
              <a:xfrm>
                <a:off x="872343" y="3609188"/>
                <a:ext cx="39747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90" name="CasellaDiTesto 89">
                <a:extLst>
                  <a:ext uri="{FF2B5EF4-FFF2-40B4-BE49-F238E27FC236}">
                    <a16:creationId xmlns:a16="http://schemas.microsoft.com/office/drawing/2014/main" id="{35E93DFF-185A-E7DA-D018-06E27C87BFA7}"/>
                  </a:ext>
                </a:extLst>
              </p:cNvPr>
              <p:cNvSpPr txBox="1"/>
              <p:nvPr/>
            </p:nvSpPr>
            <p:spPr>
              <a:xfrm>
                <a:off x="937404" y="3748234"/>
                <a:ext cx="3261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91" name="CasellaDiTesto 90">
                <a:extLst>
                  <a:ext uri="{FF2B5EF4-FFF2-40B4-BE49-F238E27FC236}">
                    <a16:creationId xmlns:a16="http://schemas.microsoft.com/office/drawing/2014/main" id="{F0C5EBEF-39F2-491E-0A2F-BAAE2A681D65}"/>
                  </a:ext>
                </a:extLst>
              </p:cNvPr>
              <p:cNvSpPr txBox="1"/>
              <p:nvPr/>
            </p:nvSpPr>
            <p:spPr>
              <a:xfrm>
                <a:off x="942850" y="3941452"/>
                <a:ext cx="323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92" name="CasellaDiTesto 91">
                <a:extLst>
                  <a:ext uri="{FF2B5EF4-FFF2-40B4-BE49-F238E27FC236}">
                    <a16:creationId xmlns:a16="http://schemas.microsoft.com/office/drawing/2014/main" id="{AB3494E7-6C05-EF8E-401E-C36715B5E464}"/>
                  </a:ext>
                </a:extLst>
              </p:cNvPr>
              <p:cNvSpPr txBox="1"/>
              <p:nvPr/>
            </p:nvSpPr>
            <p:spPr>
              <a:xfrm>
                <a:off x="922852" y="4413408"/>
                <a:ext cx="323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93" name="CasellaDiTesto 92">
                <a:extLst>
                  <a:ext uri="{FF2B5EF4-FFF2-40B4-BE49-F238E27FC236}">
                    <a16:creationId xmlns:a16="http://schemas.microsoft.com/office/drawing/2014/main" id="{5A24B2E3-4129-EF0D-84EB-75694512BEA8}"/>
                  </a:ext>
                </a:extLst>
              </p:cNvPr>
              <p:cNvSpPr txBox="1"/>
              <p:nvPr/>
            </p:nvSpPr>
            <p:spPr>
              <a:xfrm>
                <a:off x="927595" y="4659305"/>
                <a:ext cx="31782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94" name="CasellaDiTesto 93">
                <a:extLst>
                  <a:ext uri="{FF2B5EF4-FFF2-40B4-BE49-F238E27FC236}">
                    <a16:creationId xmlns:a16="http://schemas.microsoft.com/office/drawing/2014/main" id="{B52B0BAA-0FA8-5BCC-C554-205CE5DC3960}"/>
                  </a:ext>
                </a:extLst>
              </p:cNvPr>
              <p:cNvSpPr txBox="1"/>
              <p:nvPr/>
            </p:nvSpPr>
            <p:spPr>
              <a:xfrm>
                <a:off x="843064" y="3300228"/>
                <a:ext cx="43701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</p:grpSp>
        <p:grpSp>
          <p:nvGrpSpPr>
            <p:cNvPr id="154" name="Gruppo 153">
              <a:extLst>
                <a:ext uri="{FF2B5EF4-FFF2-40B4-BE49-F238E27FC236}">
                  <a16:creationId xmlns:a16="http://schemas.microsoft.com/office/drawing/2014/main" id="{1FED5F86-4EFA-7617-489F-DAA0AC94D86B}"/>
                </a:ext>
              </a:extLst>
            </p:cNvPr>
            <p:cNvGrpSpPr/>
            <p:nvPr/>
          </p:nvGrpSpPr>
          <p:grpSpPr>
            <a:xfrm>
              <a:off x="4050202" y="2667338"/>
              <a:ext cx="1673239" cy="413297"/>
              <a:chOff x="4337831" y="1880837"/>
              <a:chExt cx="1673239" cy="413297"/>
            </a:xfrm>
          </p:grpSpPr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id="{DA0D58DA-40D5-AF3A-D62C-61F2A9AEDBE5}"/>
                  </a:ext>
                </a:extLst>
              </p:cNvPr>
              <p:cNvSpPr txBox="1"/>
              <p:nvPr/>
            </p:nvSpPr>
            <p:spPr>
              <a:xfrm>
                <a:off x="4337831" y="2047898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DE9B84F9-68A6-F1EA-F3EB-6FC644CBE5F4}"/>
                  </a:ext>
                </a:extLst>
              </p:cNvPr>
              <p:cNvSpPr txBox="1"/>
              <p:nvPr/>
            </p:nvSpPr>
            <p:spPr>
              <a:xfrm>
                <a:off x="4745969" y="2047913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6" name="CasellaDiTesto 35">
                <a:extLst>
                  <a:ext uri="{FF2B5EF4-FFF2-40B4-BE49-F238E27FC236}">
                    <a16:creationId xmlns:a16="http://schemas.microsoft.com/office/drawing/2014/main" id="{D894B472-1D88-9022-EB8B-55D0838E1895}"/>
                  </a:ext>
                </a:extLst>
              </p:cNvPr>
              <p:cNvSpPr txBox="1"/>
              <p:nvPr/>
            </p:nvSpPr>
            <p:spPr>
              <a:xfrm>
                <a:off x="4939900" y="2047913"/>
                <a:ext cx="408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D6F816EE-0408-9175-A4A7-CE8A26673E54}"/>
                  </a:ext>
                </a:extLst>
              </p:cNvPr>
              <p:cNvSpPr txBox="1"/>
              <p:nvPr/>
            </p:nvSpPr>
            <p:spPr>
              <a:xfrm>
                <a:off x="5261383" y="2047913"/>
                <a:ext cx="4369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E0B62E31-A694-B4CC-0213-A36706853EBA}"/>
                  </a:ext>
                </a:extLst>
              </p:cNvPr>
              <p:cNvSpPr txBox="1"/>
              <p:nvPr/>
            </p:nvSpPr>
            <p:spPr>
              <a:xfrm>
                <a:off x="5643480" y="2047913"/>
                <a:ext cx="2605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7" name="CasellaDiTesto 96">
                <a:extLst>
                  <a:ext uri="{FF2B5EF4-FFF2-40B4-BE49-F238E27FC236}">
                    <a16:creationId xmlns:a16="http://schemas.microsoft.com/office/drawing/2014/main" id="{AAD59B4D-51E6-98E9-D210-D20243C801E5}"/>
                  </a:ext>
                </a:extLst>
              </p:cNvPr>
              <p:cNvSpPr txBox="1"/>
              <p:nvPr/>
            </p:nvSpPr>
            <p:spPr>
              <a:xfrm>
                <a:off x="4605101" y="1880837"/>
                <a:ext cx="14059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 </a:t>
                </a:r>
                <a:r>
                  <a:rPr lang="it-IT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tract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g/mL)</a:t>
                </a:r>
              </a:p>
            </p:txBody>
          </p:sp>
        </p:grpSp>
        <p:grpSp>
          <p:nvGrpSpPr>
            <p:cNvPr id="155" name="Gruppo 154">
              <a:extLst>
                <a:ext uri="{FF2B5EF4-FFF2-40B4-BE49-F238E27FC236}">
                  <a16:creationId xmlns:a16="http://schemas.microsoft.com/office/drawing/2014/main" id="{4EAD2E81-8A94-1ACB-0BA8-9CF186530474}"/>
                </a:ext>
              </a:extLst>
            </p:cNvPr>
            <p:cNvGrpSpPr/>
            <p:nvPr/>
          </p:nvGrpSpPr>
          <p:grpSpPr>
            <a:xfrm>
              <a:off x="1930281" y="2667338"/>
              <a:ext cx="1579822" cy="410415"/>
              <a:chOff x="4449565" y="1883719"/>
              <a:chExt cx="1579822" cy="410415"/>
            </a:xfrm>
          </p:grpSpPr>
          <p:sp>
            <p:nvSpPr>
              <p:cNvPr id="156" name="CasellaDiTesto 155">
                <a:extLst>
                  <a:ext uri="{FF2B5EF4-FFF2-40B4-BE49-F238E27FC236}">
                    <a16:creationId xmlns:a16="http://schemas.microsoft.com/office/drawing/2014/main" id="{023E6084-071E-A47B-82A4-90251286B262}"/>
                  </a:ext>
                </a:extLst>
              </p:cNvPr>
              <p:cNvSpPr txBox="1"/>
              <p:nvPr/>
            </p:nvSpPr>
            <p:spPr>
              <a:xfrm>
                <a:off x="4449565" y="2040156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57" name="CasellaDiTesto 156">
                <a:extLst>
                  <a:ext uri="{FF2B5EF4-FFF2-40B4-BE49-F238E27FC236}">
                    <a16:creationId xmlns:a16="http://schemas.microsoft.com/office/drawing/2014/main" id="{E80D12E3-22C6-A22A-BA59-488034639B36}"/>
                  </a:ext>
                </a:extLst>
              </p:cNvPr>
              <p:cNvSpPr txBox="1"/>
              <p:nvPr/>
            </p:nvSpPr>
            <p:spPr>
              <a:xfrm>
                <a:off x="4771048" y="2047912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58" name="CasellaDiTesto 157">
                <a:extLst>
                  <a:ext uri="{FF2B5EF4-FFF2-40B4-BE49-F238E27FC236}">
                    <a16:creationId xmlns:a16="http://schemas.microsoft.com/office/drawing/2014/main" id="{F0160B3B-FAAD-4C7A-67FD-39043D787F62}"/>
                  </a:ext>
                </a:extLst>
              </p:cNvPr>
              <p:cNvSpPr txBox="1"/>
              <p:nvPr/>
            </p:nvSpPr>
            <p:spPr>
              <a:xfrm>
                <a:off x="4964334" y="2047911"/>
                <a:ext cx="408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59" name="CasellaDiTesto 158">
                <a:extLst>
                  <a:ext uri="{FF2B5EF4-FFF2-40B4-BE49-F238E27FC236}">
                    <a16:creationId xmlns:a16="http://schemas.microsoft.com/office/drawing/2014/main" id="{3BB335E2-2F8A-3494-BD5D-CDA13E8A732E}"/>
                  </a:ext>
                </a:extLst>
              </p:cNvPr>
              <p:cNvSpPr txBox="1"/>
              <p:nvPr/>
            </p:nvSpPr>
            <p:spPr>
              <a:xfrm>
                <a:off x="5278044" y="2047910"/>
                <a:ext cx="4369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160" name="CasellaDiTesto 159">
                <a:extLst>
                  <a:ext uri="{FF2B5EF4-FFF2-40B4-BE49-F238E27FC236}">
                    <a16:creationId xmlns:a16="http://schemas.microsoft.com/office/drawing/2014/main" id="{E24F853E-2960-BE76-8DF1-2C9F2C5BF8A9}"/>
                  </a:ext>
                </a:extLst>
              </p:cNvPr>
              <p:cNvSpPr txBox="1"/>
              <p:nvPr/>
            </p:nvSpPr>
            <p:spPr>
              <a:xfrm>
                <a:off x="5643480" y="2047913"/>
                <a:ext cx="2605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61" name="CasellaDiTesto 160">
                <a:extLst>
                  <a:ext uri="{FF2B5EF4-FFF2-40B4-BE49-F238E27FC236}">
                    <a16:creationId xmlns:a16="http://schemas.microsoft.com/office/drawing/2014/main" id="{0A99DFDD-6AD7-42D8-ED61-AA76696870E8}"/>
                  </a:ext>
                </a:extLst>
              </p:cNvPr>
              <p:cNvSpPr txBox="1"/>
              <p:nvPr/>
            </p:nvSpPr>
            <p:spPr>
              <a:xfrm>
                <a:off x="4623418" y="1883719"/>
                <a:ext cx="14059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 </a:t>
                </a:r>
                <a:r>
                  <a:rPr lang="it-IT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tract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g/mL)</a:t>
                </a:r>
              </a:p>
            </p:txBody>
          </p:sp>
        </p:grpSp>
      </p:grpSp>
      <p:grpSp>
        <p:nvGrpSpPr>
          <p:cNvPr id="233" name="Gruppo 232">
            <a:extLst>
              <a:ext uri="{FF2B5EF4-FFF2-40B4-BE49-F238E27FC236}">
                <a16:creationId xmlns:a16="http://schemas.microsoft.com/office/drawing/2014/main" id="{EDE30286-66AB-16C0-2A07-93D778C35796}"/>
              </a:ext>
            </a:extLst>
          </p:cNvPr>
          <p:cNvGrpSpPr/>
          <p:nvPr/>
        </p:nvGrpSpPr>
        <p:grpSpPr>
          <a:xfrm>
            <a:off x="188178" y="339397"/>
            <a:ext cx="5199824" cy="2153975"/>
            <a:chOff x="359818" y="308386"/>
            <a:chExt cx="5199824" cy="2153975"/>
          </a:xfrm>
        </p:grpSpPr>
        <p:grpSp>
          <p:nvGrpSpPr>
            <p:cNvPr id="162" name="Gruppo 161">
              <a:extLst>
                <a:ext uri="{FF2B5EF4-FFF2-40B4-BE49-F238E27FC236}">
                  <a16:creationId xmlns:a16="http://schemas.microsoft.com/office/drawing/2014/main" id="{2CA31AD2-40B0-3407-09F2-EBBEAB68BAAF}"/>
                </a:ext>
              </a:extLst>
            </p:cNvPr>
            <p:cNvGrpSpPr/>
            <p:nvPr/>
          </p:nvGrpSpPr>
          <p:grpSpPr>
            <a:xfrm>
              <a:off x="1883575" y="308386"/>
              <a:ext cx="1578845" cy="410638"/>
              <a:chOff x="4449565" y="1883496"/>
              <a:chExt cx="1578845" cy="410638"/>
            </a:xfrm>
          </p:grpSpPr>
          <p:sp>
            <p:nvSpPr>
              <p:cNvPr id="163" name="CasellaDiTesto 162">
                <a:extLst>
                  <a:ext uri="{FF2B5EF4-FFF2-40B4-BE49-F238E27FC236}">
                    <a16:creationId xmlns:a16="http://schemas.microsoft.com/office/drawing/2014/main" id="{69EA30FE-D714-07F4-7DE8-C529F6C68144}"/>
                  </a:ext>
                </a:extLst>
              </p:cNvPr>
              <p:cNvSpPr txBox="1"/>
              <p:nvPr/>
            </p:nvSpPr>
            <p:spPr>
              <a:xfrm>
                <a:off x="4449565" y="2040156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64" name="CasellaDiTesto 163">
                <a:extLst>
                  <a:ext uri="{FF2B5EF4-FFF2-40B4-BE49-F238E27FC236}">
                    <a16:creationId xmlns:a16="http://schemas.microsoft.com/office/drawing/2014/main" id="{4B2A4CED-5DE5-C120-28E2-83F56699B3FD}"/>
                  </a:ext>
                </a:extLst>
              </p:cNvPr>
              <p:cNvSpPr txBox="1"/>
              <p:nvPr/>
            </p:nvSpPr>
            <p:spPr>
              <a:xfrm>
                <a:off x="4771048" y="2047912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65" name="CasellaDiTesto 164">
                <a:extLst>
                  <a:ext uri="{FF2B5EF4-FFF2-40B4-BE49-F238E27FC236}">
                    <a16:creationId xmlns:a16="http://schemas.microsoft.com/office/drawing/2014/main" id="{2CE3964E-A32E-6A22-A66B-913182FE6C73}"/>
                  </a:ext>
                </a:extLst>
              </p:cNvPr>
              <p:cNvSpPr txBox="1"/>
              <p:nvPr/>
            </p:nvSpPr>
            <p:spPr>
              <a:xfrm>
                <a:off x="4964334" y="2047911"/>
                <a:ext cx="408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66" name="CasellaDiTesto 165">
                <a:extLst>
                  <a:ext uri="{FF2B5EF4-FFF2-40B4-BE49-F238E27FC236}">
                    <a16:creationId xmlns:a16="http://schemas.microsoft.com/office/drawing/2014/main" id="{05DC764C-428B-C325-8191-29D85E07C0A2}"/>
                  </a:ext>
                </a:extLst>
              </p:cNvPr>
              <p:cNvSpPr txBox="1"/>
              <p:nvPr/>
            </p:nvSpPr>
            <p:spPr>
              <a:xfrm>
                <a:off x="5278044" y="2047910"/>
                <a:ext cx="4369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167" name="CasellaDiTesto 166">
                <a:extLst>
                  <a:ext uri="{FF2B5EF4-FFF2-40B4-BE49-F238E27FC236}">
                    <a16:creationId xmlns:a16="http://schemas.microsoft.com/office/drawing/2014/main" id="{D4788EBD-1A3C-52CD-BA5A-CD834F0CD6B9}"/>
                  </a:ext>
                </a:extLst>
              </p:cNvPr>
              <p:cNvSpPr txBox="1"/>
              <p:nvPr/>
            </p:nvSpPr>
            <p:spPr>
              <a:xfrm>
                <a:off x="5643480" y="2047913"/>
                <a:ext cx="2605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68" name="CasellaDiTesto 167">
                <a:extLst>
                  <a:ext uri="{FF2B5EF4-FFF2-40B4-BE49-F238E27FC236}">
                    <a16:creationId xmlns:a16="http://schemas.microsoft.com/office/drawing/2014/main" id="{74D679A6-51DE-5A87-76D7-E4A5F126E37B}"/>
                  </a:ext>
                </a:extLst>
              </p:cNvPr>
              <p:cNvSpPr txBox="1"/>
              <p:nvPr/>
            </p:nvSpPr>
            <p:spPr>
              <a:xfrm>
                <a:off x="4622441" y="1883496"/>
                <a:ext cx="14059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 </a:t>
                </a:r>
                <a:r>
                  <a:rPr lang="it-IT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tract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g/mL)</a:t>
                </a:r>
              </a:p>
            </p:txBody>
          </p:sp>
        </p:grpSp>
        <p:grpSp>
          <p:nvGrpSpPr>
            <p:cNvPr id="169" name="Gruppo 168">
              <a:extLst>
                <a:ext uri="{FF2B5EF4-FFF2-40B4-BE49-F238E27FC236}">
                  <a16:creationId xmlns:a16="http://schemas.microsoft.com/office/drawing/2014/main" id="{8DA31148-A4D0-5012-D5EA-17212F0B577A}"/>
                </a:ext>
              </a:extLst>
            </p:cNvPr>
            <p:cNvGrpSpPr/>
            <p:nvPr/>
          </p:nvGrpSpPr>
          <p:grpSpPr>
            <a:xfrm>
              <a:off x="4036623" y="313895"/>
              <a:ext cx="1523019" cy="417741"/>
              <a:chOff x="4478077" y="1876393"/>
              <a:chExt cx="1523019" cy="417741"/>
            </a:xfrm>
          </p:grpSpPr>
          <p:sp>
            <p:nvSpPr>
              <p:cNvPr id="170" name="CasellaDiTesto 169">
                <a:extLst>
                  <a:ext uri="{FF2B5EF4-FFF2-40B4-BE49-F238E27FC236}">
                    <a16:creationId xmlns:a16="http://schemas.microsoft.com/office/drawing/2014/main" id="{97CF8788-FA31-26E8-2589-FAE966FEB1F8}"/>
                  </a:ext>
                </a:extLst>
              </p:cNvPr>
              <p:cNvSpPr txBox="1"/>
              <p:nvPr/>
            </p:nvSpPr>
            <p:spPr>
              <a:xfrm>
                <a:off x="4478077" y="2047912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71" name="CasellaDiTesto 170">
                <a:extLst>
                  <a:ext uri="{FF2B5EF4-FFF2-40B4-BE49-F238E27FC236}">
                    <a16:creationId xmlns:a16="http://schemas.microsoft.com/office/drawing/2014/main" id="{606B20FD-7CFE-172B-1CEB-90C14FDE55DC}"/>
                  </a:ext>
                </a:extLst>
              </p:cNvPr>
              <p:cNvSpPr txBox="1"/>
              <p:nvPr/>
            </p:nvSpPr>
            <p:spPr>
              <a:xfrm>
                <a:off x="4745969" y="2047913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2" name="CasellaDiTesto 171">
                <a:extLst>
                  <a:ext uri="{FF2B5EF4-FFF2-40B4-BE49-F238E27FC236}">
                    <a16:creationId xmlns:a16="http://schemas.microsoft.com/office/drawing/2014/main" id="{08ACE6FC-2E58-42DC-293F-3E3746BA2375}"/>
                  </a:ext>
                </a:extLst>
              </p:cNvPr>
              <p:cNvSpPr txBox="1"/>
              <p:nvPr/>
            </p:nvSpPr>
            <p:spPr>
              <a:xfrm>
                <a:off x="4939900" y="2047913"/>
                <a:ext cx="408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73" name="CasellaDiTesto 172">
                <a:extLst>
                  <a:ext uri="{FF2B5EF4-FFF2-40B4-BE49-F238E27FC236}">
                    <a16:creationId xmlns:a16="http://schemas.microsoft.com/office/drawing/2014/main" id="{972373AF-03CF-5B98-52B4-DDE639F208BC}"/>
                  </a:ext>
                </a:extLst>
              </p:cNvPr>
              <p:cNvSpPr txBox="1"/>
              <p:nvPr/>
            </p:nvSpPr>
            <p:spPr>
              <a:xfrm>
                <a:off x="5261383" y="2047913"/>
                <a:ext cx="4369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174" name="CasellaDiTesto 173">
                <a:extLst>
                  <a:ext uri="{FF2B5EF4-FFF2-40B4-BE49-F238E27FC236}">
                    <a16:creationId xmlns:a16="http://schemas.microsoft.com/office/drawing/2014/main" id="{3F474B8A-3744-2AC2-BF18-FCC2631819F4}"/>
                  </a:ext>
                </a:extLst>
              </p:cNvPr>
              <p:cNvSpPr txBox="1"/>
              <p:nvPr/>
            </p:nvSpPr>
            <p:spPr>
              <a:xfrm>
                <a:off x="5643480" y="2047913"/>
                <a:ext cx="2605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75" name="CasellaDiTesto 174">
                <a:extLst>
                  <a:ext uri="{FF2B5EF4-FFF2-40B4-BE49-F238E27FC236}">
                    <a16:creationId xmlns:a16="http://schemas.microsoft.com/office/drawing/2014/main" id="{1139B12C-71E5-22FF-1EFF-2C8AB8F76215}"/>
                  </a:ext>
                </a:extLst>
              </p:cNvPr>
              <p:cNvSpPr txBox="1"/>
              <p:nvPr/>
            </p:nvSpPr>
            <p:spPr>
              <a:xfrm>
                <a:off x="4595127" y="1876393"/>
                <a:ext cx="14059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 </a:t>
                </a:r>
                <a:r>
                  <a:rPr lang="it-IT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tract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g/mL)</a:t>
                </a:r>
              </a:p>
            </p:txBody>
          </p:sp>
        </p:grpSp>
        <p:grpSp>
          <p:nvGrpSpPr>
            <p:cNvPr id="232" name="Gruppo 231">
              <a:extLst>
                <a:ext uri="{FF2B5EF4-FFF2-40B4-BE49-F238E27FC236}">
                  <a16:creationId xmlns:a16="http://schemas.microsoft.com/office/drawing/2014/main" id="{BC3E5A39-2177-320C-AB80-D76E66FA5CCE}"/>
                </a:ext>
              </a:extLst>
            </p:cNvPr>
            <p:cNvGrpSpPr/>
            <p:nvPr/>
          </p:nvGrpSpPr>
          <p:grpSpPr>
            <a:xfrm>
              <a:off x="359818" y="636978"/>
              <a:ext cx="5067725" cy="1825383"/>
              <a:chOff x="359818" y="636978"/>
              <a:chExt cx="5067725" cy="1825383"/>
            </a:xfrm>
          </p:grpSpPr>
          <p:sp>
            <p:nvSpPr>
              <p:cNvPr id="78" name="CasellaDiTesto 77">
                <a:extLst>
                  <a:ext uri="{FF2B5EF4-FFF2-40B4-BE49-F238E27FC236}">
                    <a16:creationId xmlns:a16="http://schemas.microsoft.com/office/drawing/2014/main" id="{E7308E8C-4A68-A0DC-06F1-435B69BFB1A1}"/>
                  </a:ext>
                </a:extLst>
              </p:cNvPr>
              <p:cNvSpPr txBox="1"/>
              <p:nvPr/>
            </p:nvSpPr>
            <p:spPr>
              <a:xfrm>
                <a:off x="359818" y="1152556"/>
                <a:ext cx="814961" cy="4757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4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X-2  </a:t>
                </a:r>
              </a:p>
              <a:p>
                <a:pPr algn="ctr"/>
                <a:r>
                  <a:rPr lang="it-IT" sz="124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74 </a:t>
                </a:r>
                <a:r>
                  <a:rPr lang="it-IT" sz="124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it-IT" sz="124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7" name="Immagine 6" descr="Immagine che contiene schermata, Rettangolo, bianco e nero, nero&#10;&#10;Descrizione generata automaticamente">
                <a:extLst>
                  <a:ext uri="{FF2B5EF4-FFF2-40B4-BE49-F238E27FC236}">
                    <a16:creationId xmlns:a16="http://schemas.microsoft.com/office/drawing/2014/main" id="{D9C3DCB5-CFA9-B2FC-904E-6E8237C728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418" t="35089" r="41484" b="37740"/>
              <a:stretch/>
            </p:blipFill>
            <p:spPr>
              <a:xfrm>
                <a:off x="1455304" y="679766"/>
                <a:ext cx="1890000" cy="1778611"/>
              </a:xfrm>
              <a:prstGeom prst="rect">
                <a:avLst/>
              </a:prstGeom>
            </p:spPr>
          </p:pic>
          <p:pic>
            <p:nvPicPr>
              <p:cNvPr id="9" name="Immagine 8" descr="Immagine che contiene bianco, schizzo, nero, bianco e nero&#10;&#10;Descrizione generata automaticamente">
                <a:extLst>
                  <a:ext uri="{FF2B5EF4-FFF2-40B4-BE49-F238E27FC236}">
                    <a16:creationId xmlns:a16="http://schemas.microsoft.com/office/drawing/2014/main" id="{B4EC75F9-883A-0B2D-7A94-BE17B54E7D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418" t="34249" r="41484" b="37741"/>
              <a:stretch/>
            </p:blipFill>
            <p:spPr>
              <a:xfrm>
                <a:off x="3594444" y="683961"/>
                <a:ext cx="1833099" cy="1778400"/>
              </a:xfrm>
              <a:prstGeom prst="rect">
                <a:avLst/>
              </a:prstGeom>
            </p:spPr>
          </p:pic>
          <p:sp>
            <p:nvSpPr>
              <p:cNvPr id="79" name="Rettangolo 78">
                <a:extLst>
                  <a:ext uri="{FF2B5EF4-FFF2-40B4-BE49-F238E27FC236}">
                    <a16:creationId xmlns:a16="http://schemas.microsoft.com/office/drawing/2014/main" id="{22B90CE1-58B1-8354-84C6-2C6E4EFC2110}"/>
                  </a:ext>
                </a:extLst>
              </p:cNvPr>
              <p:cNvSpPr/>
              <p:nvPr/>
            </p:nvSpPr>
            <p:spPr>
              <a:xfrm>
                <a:off x="1738090" y="1134948"/>
                <a:ext cx="1599122" cy="24858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701"/>
              </a:p>
            </p:txBody>
          </p:sp>
          <p:grpSp>
            <p:nvGrpSpPr>
              <p:cNvPr id="177" name="Gruppo 176">
                <a:extLst>
                  <a:ext uri="{FF2B5EF4-FFF2-40B4-BE49-F238E27FC236}">
                    <a16:creationId xmlns:a16="http://schemas.microsoft.com/office/drawing/2014/main" id="{70872898-75DE-6B87-B401-D79C9941A0DE}"/>
                  </a:ext>
                </a:extLst>
              </p:cNvPr>
              <p:cNvGrpSpPr/>
              <p:nvPr/>
            </p:nvGrpSpPr>
            <p:grpSpPr>
              <a:xfrm>
                <a:off x="1103478" y="636978"/>
                <a:ext cx="437018" cy="1589909"/>
                <a:chOff x="843064" y="3300228"/>
                <a:chExt cx="437018" cy="1589909"/>
              </a:xfrm>
            </p:grpSpPr>
            <p:sp>
              <p:nvSpPr>
                <p:cNvPr id="178" name="CasellaDiTesto 177">
                  <a:extLst>
                    <a:ext uri="{FF2B5EF4-FFF2-40B4-BE49-F238E27FC236}">
                      <a16:creationId xmlns:a16="http://schemas.microsoft.com/office/drawing/2014/main" id="{B2151C75-1786-6FCB-13A0-FD04D56A6C27}"/>
                    </a:ext>
                  </a:extLst>
                </p:cNvPr>
                <p:cNvSpPr txBox="1"/>
                <p:nvPr/>
              </p:nvSpPr>
              <p:spPr>
                <a:xfrm>
                  <a:off x="868780" y="3442601"/>
                  <a:ext cx="39981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</a:t>
                  </a:r>
                </a:p>
              </p:txBody>
            </p:sp>
            <p:sp>
              <p:nvSpPr>
                <p:cNvPr id="179" name="CasellaDiTesto 178">
                  <a:extLst>
                    <a:ext uri="{FF2B5EF4-FFF2-40B4-BE49-F238E27FC236}">
                      <a16:creationId xmlns:a16="http://schemas.microsoft.com/office/drawing/2014/main" id="{4BDAA75B-2352-575B-C9FD-9511592FDE2E}"/>
                    </a:ext>
                  </a:extLst>
                </p:cNvPr>
                <p:cNvSpPr txBox="1"/>
                <p:nvPr/>
              </p:nvSpPr>
              <p:spPr>
                <a:xfrm>
                  <a:off x="872343" y="3609188"/>
                  <a:ext cx="39747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180" name="CasellaDiTesto 179">
                  <a:extLst>
                    <a:ext uri="{FF2B5EF4-FFF2-40B4-BE49-F238E27FC236}">
                      <a16:creationId xmlns:a16="http://schemas.microsoft.com/office/drawing/2014/main" id="{4E9D3D57-3AA4-054B-046A-3967C27C6FEF}"/>
                    </a:ext>
                  </a:extLst>
                </p:cNvPr>
                <p:cNvSpPr txBox="1"/>
                <p:nvPr/>
              </p:nvSpPr>
              <p:spPr>
                <a:xfrm>
                  <a:off x="937404" y="3748234"/>
                  <a:ext cx="3261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</a:p>
              </p:txBody>
            </p:sp>
            <p:sp>
              <p:nvSpPr>
                <p:cNvPr id="181" name="CasellaDiTesto 180">
                  <a:extLst>
                    <a:ext uri="{FF2B5EF4-FFF2-40B4-BE49-F238E27FC236}">
                      <a16:creationId xmlns:a16="http://schemas.microsoft.com/office/drawing/2014/main" id="{067D7903-0EC5-1663-89E6-5C396F58888C}"/>
                    </a:ext>
                  </a:extLst>
                </p:cNvPr>
                <p:cNvSpPr txBox="1"/>
                <p:nvPr/>
              </p:nvSpPr>
              <p:spPr>
                <a:xfrm>
                  <a:off x="942850" y="3941452"/>
                  <a:ext cx="32385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</a:t>
                  </a:r>
                </a:p>
              </p:txBody>
            </p:sp>
            <p:sp>
              <p:nvSpPr>
                <p:cNvPr id="182" name="CasellaDiTesto 181">
                  <a:extLst>
                    <a:ext uri="{FF2B5EF4-FFF2-40B4-BE49-F238E27FC236}">
                      <a16:creationId xmlns:a16="http://schemas.microsoft.com/office/drawing/2014/main" id="{FB773F2F-AAE9-BF5D-CB27-9E4D232C4822}"/>
                    </a:ext>
                  </a:extLst>
                </p:cNvPr>
                <p:cNvSpPr txBox="1"/>
                <p:nvPr/>
              </p:nvSpPr>
              <p:spPr>
                <a:xfrm>
                  <a:off x="922852" y="4413408"/>
                  <a:ext cx="32385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183" name="CasellaDiTesto 182">
                  <a:extLst>
                    <a:ext uri="{FF2B5EF4-FFF2-40B4-BE49-F238E27FC236}">
                      <a16:creationId xmlns:a16="http://schemas.microsoft.com/office/drawing/2014/main" id="{D6054D0D-4592-5ED2-647D-7C5EF438A55B}"/>
                    </a:ext>
                  </a:extLst>
                </p:cNvPr>
                <p:cNvSpPr txBox="1"/>
                <p:nvPr/>
              </p:nvSpPr>
              <p:spPr>
                <a:xfrm>
                  <a:off x="927595" y="4659305"/>
                  <a:ext cx="31782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184" name="CasellaDiTesto 183">
                  <a:extLst>
                    <a:ext uri="{FF2B5EF4-FFF2-40B4-BE49-F238E27FC236}">
                      <a16:creationId xmlns:a16="http://schemas.microsoft.com/office/drawing/2014/main" id="{04F6933B-DA14-A63F-D7E6-29E26BCFCC98}"/>
                    </a:ext>
                  </a:extLst>
                </p:cNvPr>
                <p:cNvSpPr txBox="1"/>
                <p:nvPr/>
              </p:nvSpPr>
              <p:spPr>
                <a:xfrm>
                  <a:off x="843064" y="3300228"/>
                  <a:ext cx="43701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it-IT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</a:p>
              </p:txBody>
            </p:sp>
          </p:grpSp>
        </p:grpSp>
      </p:grpSp>
      <p:grpSp>
        <p:nvGrpSpPr>
          <p:cNvPr id="234" name="Gruppo 233">
            <a:extLst>
              <a:ext uri="{FF2B5EF4-FFF2-40B4-BE49-F238E27FC236}">
                <a16:creationId xmlns:a16="http://schemas.microsoft.com/office/drawing/2014/main" id="{1CB1F7BA-3A10-3141-D3EE-F56F7C5CC8B8}"/>
              </a:ext>
            </a:extLst>
          </p:cNvPr>
          <p:cNvGrpSpPr/>
          <p:nvPr/>
        </p:nvGrpSpPr>
        <p:grpSpPr>
          <a:xfrm>
            <a:off x="46294" y="2638920"/>
            <a:ext cx="5604739" cy="2125407"/>
            <a:chOff x="142588" y="5085654"/>
            <a:chExt cx="5604739" cy="2125407"/>
          </a:xfrm>
        </p:grpSpPr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84278913-453B-54E8-EBA5-3052A208AF4A}"/>
                </a:ext>
              </a:extLst>
            </p:cNvPr>
            <p:cNvSpPr txBox="1"/>
            <p:nvPr/>
          </p:nvSpPr>
          <p:spPr>
            <a:xfrm>
              <a:off x="142588" y="5976904"/>
              <a:ext cx="1121053" cy="475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46" b="1" dirty="0">
                  <a:latin typeface="Arial" panose="020B0604020202020204" pitchFamily="34" charset="0"/>
                  <a:cs typeface="Arial" panose="020B0604020202020204" pitchFamily="34" charset="0"/>
                </a:rPr>
                <a:t>iNOS  </a:t>
              </a:r>
            </a:p>
            <a:p>
              <a:pPr algn="ctr"/>
              <a:r>
                <a:rPr lang="it-IT" sz="1246" b="1" dirty="0">
                  <a:latin typeface="Arial" panose="020B0604020202020204" pitchFamily="34" charset="0"/>
                  <a:cs typeface="Arial" panose="020B0604020202020204" pitchFamily="34" charset="0"/>
                </a:rPr>
                <a:t>(130 </a:t>
              </a:r>
              <a:r>
                <a:rPr lang="it-IT" sz="1246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it-IT" sz="1246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pic>
          <p:nvPicPr>
            <p:cNvPr id="115" name="Immagine 114" descr="Immagine che contiene bianco e nero, Rettangolo, nebbia, Fotografia monocromatica&#10;&#10;Descrizione generata automaticamente">
              <a:extLst>
                <a:ext uri="{FF2B5EF4-FFF2-40B4-BE49-F238E27FC236}">
                  <a16:creationId xmlns:a16="http://schemas.microsoft.com/office/drawing/2014/main" id="{72D88FCF-C301-CACC-489E-6845B38AEA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36" t="38236" r="36062" b="34318"/>
            <a:stretch/>
          </p:blipFill>
          <p:spPr>
            <a:xfrm>
              <a:off x="3633412" y="5446140"/>
              <a:ext cx="1984498" cy="1764000"/>
            </a:xfrm>
            <a:prstGeom prst="rect">
              <a:avLst/>
            </a:prstGeom>
          </p:spPr>
        </p:pic>
        <p:pic>
          <p:nvPicPr>
            <p:cNvPr id="116" name="Immagine 115" descr="Immagine che contiene testo, Rettangolo, schermata, bianco e nero&#10;&#10;Descrizione generata automaticamente">
              <a:extLst>
                <a:ext uri="{FF2B5EF4-FFF2-40B4-BE49-F238E27FC236}">
                  <a16:creationId xmlns:a16="http://schemas.microsoft.com/office/drawing/2014/main" id="{52951BE2-1C85-AC2E-4093-060443DDC3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98" t="38685" r="35932" b="34189"/>
            <a:stretch/>
          </p:blipFill>
          <p:spPr>
            <a:xfrm>
              <a:off x="1451860" y="5447061"/>
              <a:ext cx="1883387" cy="1764000"/>
            </a:xfrm>
            <a:prstGeom prst="rect">
              <a:avLst/>
            </a:prstGeom>
          </p:spPr>
        </p:pic>
        <p:sp>
          <p:nvSpPr>
            <p:cNvPr id="117" name="Rettangolo 116">
              <a:extLst>
                <a:ext uri="{FF2B5EF4-FFF2-40B4-BE49-F238E27FC236}">
                  <a16:creationId xmlns:a16="http://schemas.microsoft.com/office/drawing/2014/main" id="{2D63ACEC-409C-79E1-1605-9C5F72D6AECA}"/>
                </a:ext>
              </a:extLst>
            </p:cNvPr>
            <p:cNvSpPr/>
            <p:nvPr/>
          </p:nvSpPr>
          <p:spPr>
            <a:xfrm>
              <a:off x="1824789" y="5615748"/>
              <a:ext cx="1510458" cy="265913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701"/>
            </a:p>
          </p:txBody>
        </p:sp>
        <p:grpSp>
          <p:nvGrpSpPr>
            <p:cNvPr id="187" name="Gruppo 186">
              <a:extLst>
                <a:ext uri="{FF2B5EF4-FFF2-40B4-BE49-F238E27FC236}">
                  <a16:creationId xmlns:a16="http://schemas.microsoft.com/office/drawing/2014/main" id="{D354A5B2-57F2-99E9-3C8E-933C8710C22C}"/>
                </a:ext>
              </a:extLst>
            </p:cNvPr>
            <p:cNvGrpSpPr/>
            <p:nvPr/>
          </p:nvGrpSpPr>
          <p:grpSpPr>
            <a:xfrm>
              <a:off x="1075423" y="5392515"/>
              <a:ext cx="437018" cy="1589909"/>
              <a:chOff x="843064" y="3300228"/>
              <a:chExt cx="437018" cy="1589909"/>
            </a:xfrm>
          </p:grpSpPr>
          <p:sp>
            <p:nvSpPr>
              <p:cNvPr id="188" name="CasellaDiTesto 187">
                <a:extLst>
                  <a:ext uri="{FF2B5EF4-FFF2-40B4-BE49-F238E27FC236}">
                    <a16:creationId xmlns:a16="http://schemas.microsoft.com/office/drawing/2014/main" id="{616D6E3F-8E0C-4B1B-2EBE-179CC02FCFC8}"/>
                  </a:ext>
                </a:extLst>
              </p:cNvPr>
              <p:cNvSpPr txBox="1"/>
              <p:nvPr/>
            </p:nvSpPr>
            <p:spPr>
              <a:xfrm>
                <a:off x="868780" y="3442601"/>
                <a:ext cx="3998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189" name="CasellaDiTesto 188">
                <a:extLst>
                  <a:ext uri="{FF2B5EF4-FFF2-40B4-BE49-F238E27FC236}">
                    <a16:creationId xmlns:a16="http://schemas.microsoft.com/office/drawing/2014/main" id="{65742457-46FF-B258-B970-9FA5824ADB05}"/>
                  </a:ext>
                </a:extLst>
              </p:cNvPr>
              <p:cNvSpPr txBox="1"/>
              <p:nvPr/>
            </p:nvSpPr>
            <p:spPr>
              <a:xfrm>
                <a:off x="872343" y="3609188"/>
                <a:ext cx="39747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90" name="CasellaDiTesto 189">
                <a:extLst>
                  <a:ext uri="{FF2B5EF4-FFF2-40B4-BE49-F238E27FC236}">
                    <a16:creationId xmlns:a16="http://schemas.microsoft.com/office/drawing/2014/main" id="{9EAA72B9-0F95-B972-FC47-88ADE742D553}"/>
                  </a:ext>
                </a:extLst>
              </p:cNvPr>
              <p:cNvSpPr txBox="1"/>
              <p:nvPr/>
            </p:nvSpPr>
            <p:spPr>
              <a:xfrm>
                <a:off x="937404" y="3748234"/>
                <a:ext cx="3261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191" name="CasellaDiTesto 190">
                <a:extLst>
                  <a:ext uri="{FF2B5EF4-FFF2-40B4-BE49-F238E27FC236}">
                    <a16:creationId xmlns:a16="http://schemas.microsoft.com/office/drawing/2014/main" id="{AD37697A-F7D8-9782-95FE-D920E788A643}"/>
                  </a:ext>
                </a:extLst>
              </p:cNvPr>
              <p:cNvSpPr txBox="1"/>
              <p:nvPr/>
            </p:nvSpPr>
            <p:spPr>
              <a:xfrm>
                <a:off x="942850" y="3941452"/>
                <a:ext cx="323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192" name="CasellaDiTesto 191">
                <a:extLst>
                  <a:ext uri="{FF2B5EF4-FFF2-40B4-BE49-F238E27FC236}">
                    <a16:creationId xmlns:a16="http://schemas.microsoft.com/office/drawing/2014/main" id="{88AE9CCE-A7AD-2378-E7FF-FA7EA177FA7C}"/>
                  </a:ext>
                </a:extLst>
              </p:cNvPr>
              <p:cNvSpPr txBox="1"/>
              <p:nvPr/>
            </p:nvSpPr>
            <p:spPr>
              <a:xfrm>
                <a:off x="922852" y="4413408"/>
                <a:ext cx="323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193" name="CasellaDiTesto 192">
                <a:extLst>
                  <a:ext uri="{FF2B5EF4-FFF2-40B4-BE49-F238E27FC236}">
                    <a16:creationId xmlns:a16="http://schemas.microsoft.com/office/drawing/2014/main" id="{A8953C22-FB5E-969B-27E5-86D96863C682}"/>
                  </a:ext>
                </a:extLst>
              </p:cNvPr>
              <p:cNvSpPr txBox="1"/>
              <p:nvPr/>
            </p:nvSpPr>
            <p:spPr>
              <a:xfrm>
                <a:off x="927595" y="4659305"/>
                <a:ext cx="31782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194" name="CasellaDiTesto 193">
                <a:extLst>
                  <a:ext uri="{FF2B5EF4-FFF2-40B4-BE49-F238E27FC236}">
                    <a16:creationId xmlns:a16="http://schemas.microsoft.com/office/drawing/2014/main" id="{D7F9B145-CAB4-2266-F79B-DD1662DDA690}"/>
                  </a:ext>
                </a:extLst>
              </p:cNvPr>
              <p:cNvSpPr txBox="1"/>
              <p:nvPr/>
            </p:nvSpPr>
            <p:spPr>
              <a:xfrm>
                <a:off x="843064" y="3300228"/>
                <a:ext cx="43701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</p:grpSp>
        <p:grpSp>
          <p:nvGrpSpPr>
            <p:cNvPr id="203" name="Gruppo 202">
              <a:extLst>
                <a:ext uri="{FF2B5EF4-FFF2-40B4-BE49-F238E27FC236}">
                  <a16:creationId xmlns:a16="http://schemas.microsoft.com/office/drawing/2014/main" id="{0E4B6219-9A7D-30C6-0AF9-6F66609A40F1}"/>
                </a:ext>
              </a:extLst>
            </p:cNvPr>
            <p:cNvGrpSpPr/>
            <p:nvPr/>
          </p:nvGrpSpPr>
          <p:grpSpPr>
            <a:xfrm>
              <a:off x="1878604" y="5085992"/>
              <a:ext cx="1563638" cy="410750"/>
              <a:chOff x="4465749" y="1883719"/>
              <a:chExt cx="1563638" cy="410750"/>
            </a:xfrm>
          </p:grpSpPr>
          <p:sp>
            <p:nvSpPr>
              <p:cNvPr id="204" name="CasellaDiTesto 203">
                <a:extLst>
                  <a:ext uri="{FF2B5EF4-FFF2-40B4-BE49-F238E27FC236}">
                    <a16:creationId xmlns:a16="http://schemas.microsoft.com/office/drawing/2014/main" id="{32706AFB-71A4-61CC-E519-42CA73A2100C}"/>
                  </a:ext>
                </a:extLst>
              </p:cNvPr>
              <p:cNvSpPr txBox="1"/>
              <p:nvPr/>
            </p:nvSpPr>
            <p:spPr>
              <a:xfrm>
                <a:off x="4465749" y="2048248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205" name="CasellaDiTesto 204">
                <a:extLst>
                  <a:ext uri="{FF2B5EF4-FFF2-40B4-BE49-F238E27FC236}">
                    <a16:creationId xmlns:a16="http://schemas.microsoft.com/office/drawing/2014/main" id="{AD244AD3-E149-46D8-D8AF-763116ADCAD8}"/>
                  </a:ext>
                </a:extLst>
              </p:cNvPr>
              <p:cNvSpPr txBox="1"/>
              <p:nvPr/>
            </p:nvSpPr>
            <p:spPr>
              <a:xfrm>
                <a:off x="4795324" y="2047912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06" name="CasellaDiTesto 205">
                <a:extLst>
                  <a:ext uri="{FF2B5EF4-FFF2-40B4-BE49-F238E27FC236}">
                    <a16:creationId xmlns:a16="http://schemas.microsoft.com/office/drawing/2014/main" id="{9B01ADE1-ED75-41B0-33C1-7936FDD0F215}"/>
                  </a:ext>
                </a:extLst>
              </p:cNvPr>
              <p:cNvSpPr txBox="1"/>
              <p:nvPr/>
            </p:nvSpPr>
            <p:spPr>
              <a:xfrm>
                <a:off x="4980518" y="2047911"/>
                <a:ext cx="408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207" name="CasellaDiTesto 206">
                <a:extLst>
                  <a:ext uri="{FF2B5EF4-FFF2-40B4-BE49-F238E27FC236}">
                    <a16:creationId xmlns:a16="http://schemas.microsoft.com/office/drawing/2014/main" id="{42619ACE-6B30-DEF6-3713-9448FBC61790}"/>
                  </a:ext>
                </a:extLst>
              </p:cNvPr>
              <p:cNvSpPr txBox="1"/>
              <p:nvPr/>
            </p:nvSpPr>
            <p:spPr>
              <a:xfrm>
                <a:off x="5294228" y="2047910"/>
                <a:ext cx="4369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208" name="CasellaDiTesto 207">
                <a:extLst>
                  <a:ext uri="{FF2B5EF4-FFF2-40B4-BE49-F238E27FC236}">
                    <a16:creationId xmlns:a16="http://schemas.microsoft.com/office/drawing/2014/main" id="{D6E85836-BFCA-308F-D0F6-505E9279DAC8}"/>
                  </a:ext>
                </a:extLst>
              </p:cNvPr>
              <p:cNvSpPr txBox="1"/>
              <p:nvPr/>
            </p:nvSpPr>
            <p:spPr>
              <a:xfrm>
                <a:off x="5667756" y="2047913"/>
                <a:ext cx="2605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09" name="CasellaDiTesto 208">
                <a:extLst>
                  <a:ext uri="{FF2B5EF4-FFF2-40B4-BE49-F238E27FC236}">
                    <a16:creationId xmlns:a16="http://schemas.microsoft.com/office/drawing/2014/main" id="{27939A90-DCB3-628E-2B2B-8095E55EE501}"/>
                  </a:ext>
                </a:extLst>
              </p:cNvPr>
              <p:cNvSpPr txBox="1"/>
              <p:nvPr/>
            </p:nvSpPr>
            <p:spPr>
              <a:xfrm>
                <a:off x="4623418" y="1883719"/>
                <a:ext cx="14059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 </a:t>
                </a:r>
                <a:r>
                  <a:rPr lang="it-IT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tract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g/mL)</a:t>
                </a:r>
              </a:p>
            </p:txBody>
          </p:sp>
        </p:grpSp>
        <p:grpSp>
          <p:nvGrpSpPr>
            <p:cNvPr id="210" name="Gruppo 209">
              <a:extLst>
                <a:ext uri="{FF2B5EF4-FFF2-40B4-BE49-F238E27FC236}">
                  <a16:creationId xmlns:a16="http://schemas.microsoft.com/office/drawing/2014/main" id="{2A97D086-CBF6-6329-9CF7-95A0B0613093}"/>
                </a:ext>
              </a:extLst>
            </p:cNvPr>
            <p:cNvGrpSpPr/>
            <p:nvPr/>
          </p:nvGrpSpPr>
          <p:grpSpPr>
            <a:xfrm>
              <a:off x="4183689" y="5085654"/>
              <a:ext cx="1563638" cy="410750"/>
              <a:chOff x="4465749" y="1883719"/>
              <a:chExt cx="1563638" cy="410750"/>
            </a:xfrm>
          </p:grpSpPr>
          <p:sp>
            <p:nvSpPr>
              <p:cNvPr id="211" name="CasellaDiTesto 210">
                <a:extLst>
                  <a:ext uri="{FF2B5EF4-FFF2-40B4-BE49-F238E27FC236}">
                    <a16:creationId xmlns:a16="http://schemas.microsoft.com/office/drawing/2014/main" id="{9567BE2A-CCA4-33AA-8458-3DDFA1940578}"/>
                  </a:ext>
                </a:extLst>
              </p:cNvPr>
              <p:cNvSpPr txBox="1"/>
              <p:nvPr/>
            </p:nvSpPr>
            <p:spPr>
              <a:xfrm>
                <a:off x="4465749" y="2048248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212" name="CasellaDiTesto 211">
                <a:extLst>
                  <a:ext uri="{FF2B5EF4-FFF2-40B4-BE49-F238E27FC236}">
                    <a16:creationId xmlns:a16="http://schemas.microsoft.com/office/drawing/2014/main" id="{2B983831-BAF8-C549-06CA-571188DF15BC}"/>
                  </a:ext>
                </a:extLst>
              </p:cNvPr>
              <p:cNvSpPr txBox="1"/>
              <p:nvPr/>
            </p:nvSpPr>
            <p:spPr>
              <a:xfrm>
                <a:off x="4795324" y="2047912"/>
                <a:ext cx="172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13" name="CasellaDiTesto 212">
                <a:extLst>
                  <a:ext uri="{FF2B5EF4-FFF2-40B4-BE49-F238E27FC236}">
                    <a16:creationId xmlns:a16="http://schemas.microsoft.com/office/drawing/2014/main" id="{7B8258C2-66DB-1F5B-E1A1-4A24485EC1D2}"/>
                  </a:ext>
                </a:extLst>
              </p:cNvPr>
              <p:cNvSpPr txBox="1"/>
              <p:nvPr/>
            </p:nvSpPr>
            <p:spPr>
              <a:xfrm>
                <a:off x="4980518" y="2047911"/>
                <a:ext cx="408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214" name="CasellaDiTesto 213">
                <a:extLst>
                  <a:ext uri="{FF2B5EF4-FFF2-40B4-BE49-F238E27FC236}">
                    <a16:creationId xmlns:a16="http://schemas.microsoft.com/office/drawing/2014/main" id="{3C8261A1-0379-4C0F-B849-3533130CC780}"/>
                  </a:ext>
                </a:extLst>
              </p:cNvPr>
              <p:cNvSpPr txBox="1"/>
              <p:nvPr/>
            </p:nvSpPr>
            <p:spPr>
              <a:xfrm>
                <a:off x="5294228" y="2047910"/>
                <a:ext cx="4369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215" name="CasellaDiTesto 214">
                <a:extLst>
                  <a:ext uri="{FF2B5EF4-FFF2-40B4-BE49-F238E27FC236}">
                    <a16:creationId xmlns:a16="http://schemas.microsoft.com/office/drawing/2014/main" id="{6EAC1DF7-E763-4061-E71B-B4D59F0BBDD1}"/>
                  </a:ext>
                </a:extLst>
              </p:cNvPr>
              <p:cNvSpPr txBox="1"/>
              <p:nvPr/>
            </p:nvSpPr>
            <p:spPr>
              <a:xfrm>
                <a:off x="5667756" y="2047913"/>
                <a:ext cx="2605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6" name="CasellaDiTesto 215">
                <a:extLst>
                  <a:ext uri="{FF2B5EF4-FFF2-40B4-BE49-F238E27FC236}">
                    <a16:creationId xmlns:a16="http://schemas.microsoft.com/office/drawing/2014/main" id="{D7904306-BEFD-F924-5027-44E23F5110D8}"/>
                  </a:ext>
                </a:extLst>
              </p:cNvPr>
              <p:cNvSpPr txBox="1"/>
              <p:nvPr/>
            </p:nvSpPr>
            <p:spPr>
              <a:xfrm>
                <a:off x="4623418" y="1883719"/>
                <a:ext cx="14059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 </a:t>
                </a:r>
                <a:r>
                  <a:rPr lang="it-IT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tract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g/mL)</a:t>
                </a:r>
              </a:p>
            </p:txBody>
          </p:sp>
        </p:grpSp>
      </p:grpSp>
      <p:sp>
        <p:nvSpPr>
          <p:cNvPr id="235" name="CasellaDiTesto 234">
            <a:extLst>
              <a:ext uri="{FF2B5EF4-FFF2-40B4-BE49-F238E27FC236}">
                <a16:creationId xmlns:a16="http://schemas.microsoft.com/office/drawing/2014/main" id="{C83461EB-417D-AF08-525B-CFF67AA224B2}"/>
              </a:ext>
            </a:extLst>
          </p:cNvPr>
          <p:cNvSpPr txBox="1"/>
          <p:nvPr/>
        </p:nvSpPr>
        <p:spPr>
          <a:xfrm>
            <a:off x="50593" y="8268666"/>
            <a:ext cx="658942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Effect of AM extract on COX-2 and iNOS expression in LPS-stimulated macrophages. Uncropped (left column) and representative Western blot (right column) images for the quantification of COX-2 (A) and iNOS (B) expression in J774 cells pre-treated for 2 h with AM (0.5-1 mg/mL) prior to LPS stimulation. Expression of </a:t>
            </a:r>
            <a:r>
              <a:rPr lang="el-GR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actin (C) was used as loading control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9DA95D89-8352-A88F-B1A1-1EF387B1E78A}"/>
              </a:ext>
            </a:extLst>
          </p:cNvPr>
          <p:cNvSpPr txBox="1"/>
          <p:nvPr/>
        </p:nvSpPr>
        <p:spPr>
          <a:xfrm>
            <a:off x="298948" y="249835"/>
            <a:ext cx="253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8B84A279-5653-E720-3F2E-AEFB98F50214}"/>
              </a:ext>
            </a:extLst>
          </p:cNvPr>
          <p:cNvSpPr txBox="1"/>
          <p:nvPr/>
        </p:nvSpPr>
        <p:spPr>
          <a:xfrm>
            <a:off x="302736" y="2691865"/>
            <a:ext cx="253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E41614C0-E91A-4223-3601-2CAB685C25BC}"/>
              </a:ext>
            </a:extLst>
          </p:cNvPr>
          <p:cNvSpPr txBox="1"/>
          <p:nvPr/>
        </p:nvSpPr>
        <p:spPr>
          <a:xfrm>
            <a:off x="308711" y="5019010"/>
            <a:ext cx="253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529194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66C6EF5D-37A9-C337-416B-DBE2BB0563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6095414"/>
              </p:ext>
            </p:extLst>
          </p:nvPr>
        </p:nvGraphicFramePr>
        <p:xfrm>
          <a:off x="324465" y="172833"/>
          <a:ext cx="6209069" cy="7466816"/>
        </p:xfrm>
        <a:graphic>
          <a:graphicData uri="http://schemas.openxmlformats.org/drawingml/2006/table">
            <a:tbl>
              <a:tblPr/>
              <a:tblGrid>
                <a:gridCol w="715901">
                  <a:extLst>
                    <a:ext uri="{9D8B030D-6E8A-4147-A177-3AD203B41FA5}">
                      <a16:colId xmlns:a16="http://schemas.microsoft.com/office/drawing/2014/main" val="3787438755"/>
                    </a:ext>
                  </a:extLst>
                </a:gridCol>
                <a:gridCol w="715901">
                  <a:extLst>
                    <a:ext uri="{9D8B030D-6E8A-4147-A177-3AD203B41FA5}">
                      <a16:colId xmlns:a16="http://schemas.microsoft.com/office/drawing/2014/main" val="3432023554"/>
                    </a:ext>
                  </a:extLst>
                </a:gridCol>
                <a:gridCol w="853575">
                  <a:extLst>
                    <a:ext uri="{9D8B030D-6E8A-4147-A177-3AD203B41FA5}">
                      <a16:colId xmlns:a16="http://schemas.microsoft.com/office/drawing/2014/main" val="1385850030"/>
                    </a:ext>
                  </a:extLst>
                </a:gridCol>
                <a:gridCol w="2574492">
                  <a:extLst>
                    <a:ext uri="{9D8B030D-6E8A-4147-A177-3AD203B41FA5}">
                      <a16:colId xmlns:a16="http://schemas.microsoft.com/office/drawing/2014/main" val="2911023261"/>
                    </a:ext>
                  </a:extLst>
                </a:gridCol>
                <a:gridCol w="674600">
                  <a:extLst>
                    <a:ext uri="{9D8B030D-6E8A-4147-A177-3AD203B41FA5}">
                      <a16:colId xmlns:a16="http://schemas.microsoft.com/office/drawing/2014/main" val="3233462752"/>
                    </a:ext>
                  </a:extLst>
                </a:gridCol>
                <a:gridCol w="674600">
                  <a:extLst>
                    <a:ext uri="{9D8B030D-6E8A-4147-A177-3AD203B41FA5}">
                      <a16:colId xmlns:a16="http://schemas.microsoft.com/office/drawing/2014/main" val="1571608496"/>
                    </a:ext>
                  </a:extLst>
                </a:gridCol>
              </a:tblGrid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1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3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well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ecul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814145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empfe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725837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empfe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830355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7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empfe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2704305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empfe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3419301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2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ceatann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0445776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2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ceatann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6856651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1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,7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is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2497459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1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is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5502157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9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34111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9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9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513377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9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0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184662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9,1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0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ring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3149742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9,1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ring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780310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7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5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verat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7963019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7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verat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594862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6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rice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0050768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6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rice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5738678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6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,7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iodicty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0726176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6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4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iodicty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13542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6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airesin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7784031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6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airesin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9819975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1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2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terodi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3825382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1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terodi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2099349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erce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9036610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,6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erce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491970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4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4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anid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31773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4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anid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1012037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553372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4672675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7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4225965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9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582032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6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terolactone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905613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6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3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terolactone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394875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8,7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l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171365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8,7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l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9854365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5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ech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5342200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ech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4267070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6,6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,1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nill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0519809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6,6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nill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37937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,7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4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ffe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997464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,7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,2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ffe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693439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)Epicatech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41985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,1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)Epicatech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868500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,7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phinid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002266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,9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phinid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374176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largonid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4275687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,7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largonid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964701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3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-p-Coumar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5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77477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3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-p-Coumaric acid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5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04429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3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espere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4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3789347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,8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esperet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4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8872423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,6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iste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4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495377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,6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9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istein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4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0115125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7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0,9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umest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1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8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922304"/>
                  </a:ext>
                </a:extLst>
              </a:tr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7,00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8,8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umestrol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0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4,00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6276422"/>
                  </a:ext>
                </a:extLst>
              </a:tr>
            </a:tbl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7DE41A81-3352-ABF8-B686-00766E325661}"/>
              </a:ext>
            </a:extLst>
          </p:cNvPr>
          <p:cNvSpPr txBox="1"/>
          <p:nvPr/>
        </p:nvSpPr>
        <p:spPr>
          <a:xfrm>
            <a:off x="50593" y="8268666"/>
            <a:ext cx="65894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ecursor ions, product ions, collision energy, and </a:t>
            </a:r>
            <a:r>
              <a:rPr lang="en-US" sz="120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eclustering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potential parameters of MRM analysis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5222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7DE41A81-3352-ABF8-B686-00766E325661}"/>
              </a:ext>
            </a:extLst>
          </p:cNvPr>
          <p:cNvSpPr txBox="1"/>
          <p:nvPr/>
        </p:nvSpPr>
        <p:spPr>
          <a:xfrm>
            <a:off x="50593" y="8268666"/>
            <a:ext cx="65894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ecursor ions, product ions, collision energy, and </a:t>
            </a:r>
            <a:r>
              <a:rPr lang="en-US" sz="120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eclustering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potential parameters of MRM analysis.</a:t>
            </a:r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8BC511E1-A7D7-6892-9D5E-165D97D164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3851233"/>
              </p:ext>
            </p:extLst>
          </p:nvPr>
        </p:nvGraphicFramePr>
        <p:xfrm>
          <a:off x="186033" y="611611"/>
          <a:ext cx="6485934" cy="721476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47824">
                  <a:extLst>
                    <a:ext uri="{9D8B030D-6E8A-4147-A177-3AD203B41FA5}">
                      <a16:colId xmlns:a16="http://schemas.microsoft.com/office/drawing/2014/main" val="500087077"/>
                    </a:ext>
                  </a:extLst>
                </a:gridCol>
                <a:gridCol w="747824">
                  <a:extLst>
                    <a:ext uri="{9D8B030D-6E8A-4147-A177-3AD203B41FA5}">
                      <a16:colId xmlns:a16="http://schemas.microsoft.com/office/drawing/2014/main" val="576568806"/>
                    </a:ext>
                  </a:extLst>
                </a:gridCol>
                <a:gridCol w="891636">
                  <a:extLst>
                    <a:ext uri="{9D8B030D-6E8A-4147-A177-3AD203B41FA5}">
                      <a16:colId xmlns:a16="http://schemas.microsoft.com/office/drawing/2014/main" val="1455753961"/>
                    </a:ext>
                  </a:extLst>
                </a:gridCol>
                <a:gridCol w="2689290">
                  <a:extLst>
                    <a:ext uri="{9D8B030D-6E8A-4147-A177-3AD203B41FA5}">
                      <a16:colId xmlns:a16="http://schemas.microsoft.com/office/drawing/2014/main" val="860342409"/>
                    </a:ext>
                  </a:extLst>
                </a:gridCol>
                <a:gridCol w="704680">
                  <a:extLst>
                    <a:ext uri="{9D8B030D-6E8A-4147-A177-3AD203B41FA5}">
                      <a16:colId xmlns:a16="http://schemas.microsoft.com/office/drawing/2014/main" val="1856849323"/>
                    </a:ext>
                  </a:extLst>
                </a:gridCol>
                <a:gridCol w="704680">
                  <a:extLst>
                    <a:ext uri="{9D8B030D-6E8A-4147-A177-3AD203B41FA5}">
                      <a16:colId xmlns:a16="http://schemas.microsoft.com/office/drawing/2014/main" val="1576867896"/>
                    </a:ext>
                  </a:extLst>
                </a:gridCol>
              </a:tblGrid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8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16,9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pigen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6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4221754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8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50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pigen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13523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6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51,7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Formon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9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2581775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6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22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Formon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9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3938796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2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7,5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Glycite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10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792987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2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Glycite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10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2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364371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2,9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7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Biochanin A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7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1358345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2,9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38,8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Biochanin A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7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5242546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54,9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39,9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terosilben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3596612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Luteolin-6-c-glucoside (ISOORIENTIN)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6560889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Luteolin-6-c-glucoside (ISOORIENTIN)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248664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7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Luteolin-6-c-glucoside (ISOORIENTIN)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533232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pigenin-8-c-glucoside (VITEXIN)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6025582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pigenin-8-c-glucoside (VITEXIN)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9944693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4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pigenin-8-c-glucoside (VITEXIN)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8614751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0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-3-O-galact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37989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-3-O-galact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38359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Kaempferol-3-O-rutinosid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6492063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Kaempferol-3-O-rutinosid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9230101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0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Isorhamn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8249535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5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Isorhamn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0468258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Isorhamn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1438111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3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3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mentoflavon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6670492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3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7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mentoflavon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7800439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Caffeoylquinic</a:t>
                      </a:r>
                      <a:r>
                        <a:rPr lang="it-IT" sz="700" u="none" strike="noStrike" dirty="0">
                          <a:effectLst/>
                        </a:rPr>
                        <a:t> acid derivativ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0729809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7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Caffeoylquinic</a:t>
                      </a:r>
                      <a:r>
                        <a:rPr lang="it-IT" sz="700" u="none" strike="noStrike" dirty="0">
                          <a:effectLst/>
                        </a:rPr>
                        <a:t> acid derivativ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5310576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60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Quercetin</a:t>
                      </a:r>
                      <a:r>
                        <a:rPr lang="it-IT" sz="700" u="none" strike="noStrike" dirty="0">
                          <a:effectLst/>
                        </a:rPr>
                        <a:t> </a:t>
                      </a:r>
                      <a:r>
                        <a:rPr lang="it-IT" sz="700" u="none" strike="noStrike" dirty="0" err="1">
                          <a:effectLst/>
                        </a:rPr>
                        <a:t>rutinosid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696218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60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0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Quercetin</a:t>
                      </a:r>
                      <a:r>
                        <a:rPr lang="it-IT" sz="700" u="none" strike="noStrike" dirty="0">
                          <a:effectLst/>
                        </a:rPr>
                        <a:t> </a:t>
                      </a:r>
                      <a:r>
                        <a:rPr lang="it-IT" sz="700" u="none" strike="noStrike" dirty="0" err="1">
                          <a:effectLst/>
                        </a:rPr>
                        <a:t>rutinosid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965920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 acetylhex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7512680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 acetylhex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7172803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8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Methyl</a:t>
                      </a:r>
                      <a:r>
                        <a:rPr lang="it-IT" sz="700" u="none" strike="noStrike" dirty="0">
                          <a:effectLst/>
                        </a:rPr>
                        <a:t> gallat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0605919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8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Methyl</a:t>
                      </a:r>
                      <a:r>
                        <a:rPr lang="it-IT" sz="700" u="none" strike="noStrike" dirty="0">
                          <a:effectLst/>
                        </a:rPr>
                        <a:t> gallat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0816723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GC-epicatechin dimer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6122799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Ethyl</a:t>
                      </a:r>
                      <a:r>
                        <a:rPr lang="it-IT" sz="700" u="none" strike="noStrike" dirty="0">
                          <a:effectLst/>
                        </a:rPr>
                        <a:t> gallat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1604571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 err="1">
                          <a:effectLst/>
                        </a:rPr>
                        <a:t>Ethyl</a:t>
                      </a:r>
                      <a:r>
                        <a:rPr lang="it-IT" sz="700" u="none" strike="noStrike" dirty="0">
                          <a:effectLst/>
                        </a:rPr>
                        <a:t> gallat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9604459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2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7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rocyanidin dimer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9810918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9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Myricetin-3-O-glucuron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5079645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7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Myricetin-3-O-gluc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073800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C-3-O-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6211760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C-3-O-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5975112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8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2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cis-Resveratrol-3-O-glucoside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0208231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6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-fisetinidol-EC isomer 2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7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2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83860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6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7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-fisetinidol-EC isomer 3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7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2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4523445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5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GC-EGC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6550088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GC-EGC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5262585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61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5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GC gallate gluc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342164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61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0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GC gallate gluc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5557364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60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5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GC di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2956060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60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0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GC di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5429984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5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C methyl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4747990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5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8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C methyl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5240624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E-Afzelechin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759819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1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Theaflavin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904696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1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Theaflavin g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823626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86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1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Theaflavin digl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044987"/>
                  </a:ext>
                </a:extLst>
              </a:tr>
              <a:tr h="12883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86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Theaflavin diglallat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-30,00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7191684"/>
                  </a:ext>
                </a:extLst>
              </a:tr>
            </a:tbl>
          </a:graphicData>
        </a:graphic>
      </p:graphicFrame>
      <p:graphicFrame>
        <p:nvGraphicFramePr>
          <p:cNvPr id="6" name="Tabella 5">
            <a:extLst>
              <a:ext uri="{FF2B5EF4-FFF2-40B4-BE49-F238E27FC236}">
                <a16:creationId xmlns:a16="http://schemas.microsoft.com/office/drawing/2014/main" id="{8B234807-1476-9EF7-4617-95E56BB2F2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9466955"/>
              </p:ext>
            </p:extLst>
          </p:nvPr>
        </p:nvGraphicFramePr>
        <p:xfrm>
          <a:off x="186033" y="478275"/>
          <a:ext cx="6485934" cy="133336"/>
        </p:xfrm>
        <a:graphic>
          <a:graphicData uri="http://schemas.openxmlformats.org/drawingml/2006/table">
            <a:tbl>
              <a:tblPr/>
              <a:tblGrid>
                <a:gridCol w="747823">
                  <a:extLst>
                    <a:ext uri="{9D8B030D-6E8A-4147-A177-3AD203B41FA5}">
                      <a16:colId xmlns:a16="http://schemas.microsoft.com/office/drawing/2014/main" val="1177979963"/>
                    </a:ext>
                  </a:extLst>
                </a:gridCol>
                <a:gridCol w="747823">
                  <a:extLst>
                    <a:ext uri="{9D8B030D-6E8A-4147-A177-3AD203B41FA5}">
                      <a16:colId xmlns:a16="http://schemas.microsoft.com/office/drawing/2014/main" val="102763309"/>
                    </a:ext>
                  </a:extLst>
                </a:gridCol>
                <a:gridCol w="891636">
                  <a:extLst>
                    <a:ext uri="{9D8B030D-6E8A-4147-A177-3AD203B41FA5}">
                      <a16:colId xmlns:a16="http://schemas.microsoft.com/office/drawing/2014/main" val="224823272"/>
                    </a:ext>
                  </a:extLst>
                </a:gridCol>
                <a:gridCol w="2689290">
                  <a:extLst>
                    <a:ext uri="{9D8B030D-6E8A-4147-A177-3AD203B41FA5}">
                      <a16:colId xmlns:a16="http://schemas.microsoft.com/office/drawing/2014/main" val="297405775"/>
                    </a:ext>
                  </a:extLst>
                </a:gridCol>
                <a:gridCol w="704681">
                  <a:extLst>
                    <a:ext uri="{9D8B030D-6E8A-4147-A177-3AD203B41FA5}">
                      <a16:colId xmlns:a16="http://schemas.microsoft.com/office/drawing/2014/main" val="1358286305"/>
                    </a:ext>
                  </a:extLst>
                </a:gridCol>
                <a:gridCol w="704681">
                  <a:extLst>
                    <a:ext uri="{9D8B030D-6E8A-4147-A177-3AD203B41FA5}">
                      <a16:colId xmlns:a16="http://schemas.microsoft.com/office/drawing/2014/main" val="2607463587"/>
                    </a:ext>
                  </a:extLst>
                </a:gridCol>
              </a:tblGrid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1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3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well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ecul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21505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029484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7DE41A81-3352-ABF8-B686-00766E325661}"/>
              </a:ext>
            </a:extLst>
          </p:cNvPr>
          <p:cNvSpPr txBox="1"/>
          <p:nvPr/>
        </p:nvSpPr>
        <p:spPr>
          <a:xfrm>
            <a:off x="50593" y="8268666"/>
            <a:ext cx="65894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ecursor ions, product ions, collision energy, and </a:t>
            </a:r>
            <a:r>
              <a:rPr lang="en-US" sz="120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eclustering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potential parameters of MRM analysis.</a:t>
            </a:r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ella 5">
            <a:extLst>
              <a:ext uri="{FF2B5EF4-FFF2-40B4-BE49-F238E27FC236}">
                <a16:creationId xmlns:a16="http://schemas.microsoft.com/office/drawing/2014/main" id="{8B234807-1476-9EF7-4617-95E56BB2F28D}"/>
              </a:ext>
            </a:extLst>
          </p:cNvPr>
          <p:cNvGraphicFramePr>
            <a:graphicFrameLocks noGrp="1"/>
          </p:cNvGraphicFramePr>
          <p:nvPr/>
        </p:nvGraphicFramePr>
        <p:xfrm>
          <a:off x="186033" y="478275"/>
          <a:ext cx="6485934" cy="133336"/>
        </p:xfrm>
        <a:graphic>
          <a:graphicData uri="http://schemas.openxmlformats.org/drawingml/2006/table">
            <a:tbl>
              <a:tblPr/>
              <a:tblGrid>
                <a:gridCol w="747823">
                  <a:extLst>
                    <a:ext uri="{9D8B030D-6E8A-4147-A177-3AD203B41FA5}">
                      <a16:colId xmlns:a16="http://schemas.microsoft.com/office/drawing/2014/main" val="1177979963"/>
                    </a:ext>
                  </a:extLst>
                </a:gridCol>
                <a:gridCol w="747823">
                  <a:extLst>
                    <a:ext uri="{9D8B030D-6E8A-4147-A177-3AD203B41FA5}">
                      <a16:colId xmlns:a16="http://schemas.microsoft.com/office/drawing/2014/main" val="102763309"/>
                    </a:ext>
                  </a:extLst>
                </a:gridCol>
                <a:gridCol w="891636">
                  <a:extLst>
                    <a:ext uri="{9D8B030D-6E8A-4147-A177-3AD203B41FA5}">
                      <a16:colId xmlns:a16="http://schemas.microsoft.com/office/drawing/2014/main" val="224823272"/>
                    </a:ext>
                  </a:extLst>
                </a:gridCol>
                <a:gridCol w="2689290">
                  <a:extLst>
                    <a:ext uri="{9D8B030D-6E8A-4147-A177-3AD203B41FA5}">
                      <a16:colId xmlns:a16="http://schemas.microsoft.com/office/drawing/2014/main" val="297405775"/>
                    </a:ext>
                  </a:extLst>
                </a:gridCol>
                <a:gridCol w="704681">
                  <a:extLst>
                    <a:ext uri="{9D8B030D-6E8A-4147-A177-3AD203B41FA5}">
                      <a16:colId xmlns:a16="http://schemas.microsoft.com/office/drawing/2014/main" val="1358286305"/>
                    </a:ext>
                  </a:extLst>
                </a:gridCol>
                <a:gridCol w="704681">
                  <a:extLst>
                    <a:ext uri="{9D8B030D-6E8A-4147-A177-3AD203B41FA5}">
                      <a16:colId xmlns:a16="http://schemas.microsoft.com/office/drawing/2014/main" val="2607463587"/>
                    </a:ext>
                  </a:extLst>
                </a:gridCol>
              </a:tblGrid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1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3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well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ecul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2150525"/>
                  </a:ext>
                </a:extLst>
              </a:tr>
            </a:tbl>
          </a:graphicData>
        </a:graphic>
      </p:graphicFrame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755209D6-9CB7-D7FC-9260-B63AA9424933}"/>
              </a:ext>
            </a:extLst>
          </p:cNvPr>
          <p:cNvGraphicFramePr>
            <a:graphicFrameLocks noGrp="1"/>
          </p:cNvGraphicFramePr>
          <p:nvPr/>
        </p:nvGraphicFramePr>
        <p:xfrm>
          <a:off x="186032" y="611611"/>
          <a:ext cx="6485934" cy="740361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747823">
                  <a:extLst>
                    <a:ext uri="{9D8B030D-6E8A-4147-A177-3AD203B41FA5}">
                      <a16:colId xmlns:a16="http://schemas.microsoft.com/office/drawing/2014/main" val="2447920411"/>
                    </a:ext>
                  </a:extLst>
                </a:gridCol>
                <a:gridCol w="747823">
                  <a:extLst>
                    <a:ext uri="{9D8B030D-6E8A-4147-A177-3AD203B41FA5}">
                      <a16:colId xmlns:a16="http://schemas.microsoft.com/office/drawing/2014/main" val="3844773036"/>
                    </a:ext>
                  </a:extLst>
                </a:gridCol>
                <a:gridCol w="891637">
                  <a:extLst>
                    <a:ext uri="{9D8B030D-6E8A-4147-A177-3AD203B41FA5}">
                      <a16:colId xmlns:a16="http://schemas.microsoft.com/office/drawing/2014/main" val="1708605508"/>
                    </a:ext>
                  </a:extLst>
                </a:gridCol>
                <a:gridCol w="2689291">
                  <a:extLst>
                    <a:ext uri="{9D8B030D-6E8A-4147-A177-3AD203B41FA5}">
                      <a16:colId xmlns:a16="http://schemas.microsoft.com/office/drawing/2014/main" val="930052307"/>
                    </a:ext>
                  </a:extLst>
                </a:gridCol>
                <a:gridCol w="704680">
                  <a:extLst>
                    <a:ext uri="{9D8B030D-6E8A-4147-A177-3AD203B41FA5}">
                      <a16:colId xmlns:a16="http://schemas.microsoft.com/office/drawing/2014/main" val="311579299"/>
                    </a:ext>
                  </a:extLst>
                </a:gridCol>
                <a:gridCol w="704680">
                  <a:extLst>
                    <a:ext uri="{9D8B030D-6E8A-4147-A177-3AD203B41FA5}">
                      <a16:colId xmlns:a16="http://schemas.microsoft.com/office/drawing/2014/main" val="890911457"/>
                    </a:ext>
                  </a:extLst>
                </a:gridCol>
              </a:tblGrid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Theaflav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8194820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53,1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3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rotocatechu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908516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53,1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0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rotocatechu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46810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53,1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9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rotocatechu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948277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3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hlorogen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511385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3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hlorogen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755957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3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hlorogen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6185591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3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7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hlorogen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3748550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3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3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hlorogen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9880622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35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7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affeoyliquinic Acid Lacton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87324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35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affeoyliquinic Acid Lacton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666516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3,2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49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Ferul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800979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3,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4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Ferul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5167261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3,2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34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Ferul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248540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1,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Lina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1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472502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1,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Lina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1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6758740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1,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Lina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1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869871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15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9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uera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213547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15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2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uera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732073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15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9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uera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692531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15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8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Puera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3898346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99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Diosm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465104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99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5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Diosm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72910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99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0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Diosm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483423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99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Diosme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6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135161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69,7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6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Typhan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62470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769,7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1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Typhan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8329198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2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stragal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960568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Astragal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1708101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3,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4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oumar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4395690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3,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1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oumar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991302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3,2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9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Coumar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2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644824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37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9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-P-Coumaroylquin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931421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37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6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-P-Coumaroylquinic Acid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5802542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Orien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501566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1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Orien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7771443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5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Orien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2568762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3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Orient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832096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Luteolin-7-O-Gluc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3890122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15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Luteolin-7-O-Gluc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7847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Luteolin-7-O-Gluc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241865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77,5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7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Isorhoifol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58502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77,5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6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Isorhoifol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672811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77,5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Isorhoifol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868897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3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Hyper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9414541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3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0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Hyper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8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2744470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30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-O-Rhamn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551837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4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-O-Rhamn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038083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7,4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1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-O-Rhamn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170435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61,9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9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Quercetin-O-Hex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3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2938054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3,5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Nicotinflo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703589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3,5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57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Nicotinflo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0671362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93,5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49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Nicotinflorin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4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9397825"/>
                  </a:ext>
                </a:extLst>
              </a:tr>
              <a:tr h="137104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431,1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285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5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Kaempeferol-3-O-Rhamnoside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</a:rPr>
                        <a:t>-60,00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</a:rPr>
                        <a:t>-30,00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49" marR="4849" marT="48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83478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65134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7DE41A81-3352-ABF8-B686-00766E325661}"/>
              </a:ext>
            </a:extLst>
          </p:cNvPr>
          <p:cNvSpPr txBox="1"/>
          <p:nvPr/>
        </p:nvSpPr>
        <p:spPr>
          <a:xfrm>
            <a:off x="50593" y="8268666"/>
            <a:ext cx="65894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ecursor ions, product ions, collision energy, and </a:t>
            </a:r>
            <a:r>
              <a:rPr lang="en-US" sz="120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eclustering</a:t>
            </a:r>
            <a:r>
              <a:rPr lang="en-US" sz="12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potential parameters of MRM analysis.</a:t>
            </a:r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ella 5">
            <a:extLst>
              <a:ext uri="{FF2B5EF4-FFF2-40B4-BE49-F238E27FC236}">
                <a16:creationId xmlns:a16="http://schemas.microsoft.com/office/drawing/2014/main" id="{8B234807-1476-9EF7-4617-95E56BB2F28D}"/>
              </a:ext>
            </a:extLst>
          </p:cNvPr>
          <p:cNvGraphicFramePr>
            <a:graphicFrameLocks noGrp="1"/>
          </p:cNvGraphicFramePr>
          <p:nvPr/>
        </p:nvGraphicFramePr>
        <p:xfrm>
          <a:off x="186033" y="478275"/>
          <a:ext cx="6485934" cy="133336"/>
        </p:xfrm>
        <a:graphic>
          <a:graphicData uri="http://schemas.openxmlformats.org/drawingml/2006/table">
            <a:tbl>
              <a:tblPr/>
              <a:tblGrid>
                <a:gridCol w="747823">
                  <a:extLst>
                    <a:ext uri="{9D8B030D-6E8A-4147-A177-3AD203B41FA5}">
                      <a16:colId xmlns:a16="http://schemas.microsoft.com/office/drawing/2014/main" val="1177979963"/>
                    </a:ext>
                  </a:extLst>
                </a:gridCol>
                <a:gridCol w="747823">
                  <a:extLst>
                    <a:ext uri="{9D8B030D-6E8A-4147-A177-3AD203B41FA5}">
                      <a16:colId xmlns:a16="http://schemas.microsoft.com/office/drawing/2014/main" val="102763309"/>
                    </a:ext>
                  </a:extLst>
                </a:gridCol>
                <a:gridCol w="891636">
                  <a:extLst>
                    <a:ext uri="{9D8B030D-6E8A-4147-A177-3AD203B41FA5}">
                      <a16:colId xmlns:a16="http://schemas.microsoft.com/office/drawing/2014/main" val="224823272"/>
                    </a:ext>
                  </a:extLst>
                </a:gridCol>
                <a:gridCol w="2689290">
                  <a:extLst>
                    <a:ext uri="{9D8B030D-6E8A-4147-A177-3AD203B41FA5}">
                      <a16:colId xmlns:a16="http://schemas.microsoft.com/office/drawing/2014/main" val="297405775"/>
                    </a:ext>
                  </a:extLst>
                </a:gridCol>
                <a:gridCol w="704681">
                  <a:extLst>
                    <a:ext uri="{9D8B030D-6E8A-4147-A177-3AD203B41FA5}">
                      <a16:colId xmlns:a16="http://schemas.microsoft.com/office/drawing/2014/main" val="1358286305"/>
                    </a:ext>
                  </a:extLst>
                </a:gridCol>
                <a:gridCol w="704681">
                  <a:extLst>
                    <a:ext uri="{9D8B030D-6E8A-4147-A177-3AD203B41FA5}">
                      <a16:colId xmlns:a16="http://schemas.microsoft.com/office/drawing/2014/main" val="2607463587"/>
                    </a:ext>
                  </a:extLst>
                </a:gridCol>
              </a:tblGrid>
              <a:tr h="13333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1</a:t>
                      </a: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 3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well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ecul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</a:t>
                      </a:r>
                    </a:p>
                  </a:txBody>
                  <a:tcPr marL="4676" marR="4676" marT="46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2150525"/>
                  </a:ext>
                </a:extLst>
              </a:tr>
            </a:tbl>
          </a:graphicData>
        </a:graphic>
      </p:graphicFrame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64C9C852-88E7-D8F3-4707-3D340E6EC8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5881169"/>
              </p:ext>
            </p:extLst>
          </p:nvPr>
        </p:nvGraphicFramePr>
        <p:xfrm>
          <a:off x="186032" y="611611"/>
          <a:ext cx="6485931" cy="6284927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47823">
                  <a:extLst>
                    <a:ext uri="{9D8B030D-6E8A-4147-A177-3AD203B41FA5}">
                      <a16:colId xmlns:a16="http://schemas.microsoft.com/office/drawing/2014/main" val="2805943660"/>
                    </a:ext>
                  </a:extLst>
                </a:gridCol>
                <a:gridCol w="747823">
                  <a:extLst>
                    <a:ext uri="{9D8B030D-6E8A-4147-A177-3AD203B41FA5}">
                      <a16:colId xmlns:a16="http://schemas.microsoft.com/office/drawing/2014/main" val="1475118987"/>
                    </a:ext>
                  </a:extLst>
                </a:gridCol>
                <a:gridCol w="891636">
                  <a:extLst>
                    <a:ext uri="{9D8B030D-6E8A-4147-A177-3AD203B41FA5}">
                      <a16:colId xmlns:a16="http://schemas.microsoft.com/office/drawing/2014/main" val="1910111592"/>
                    </a:ext>
                  </a:extLst>
                </a:gridCol>
                <a:gridCol w="2689289">
                  <a:extLst>
                    <a:ext uri="{9D8B030D-6E8A-4147-A177-3AD203B41FA5}">
                      <a16:colId xmlns:a16="http://schemas.microsoft.com/office/drawing/2014/main" val="2167663456"/>
                    </a:ext>
                  </a:extLst>
                </a:gridCol>
                <a:gridCol w="704680">
                  <a:extLst>
                    <a:ext uri="{9D8B030D-6E8A-4147-A177-3AD203B41FA5}">
                      <a16:colId xmlns:a16="http://schemas.microsoft.com/office/drawing/2014/main" val="1651650065"/>
                    </a:ext>
                  </a:extLst>
                </a:gridCol>
                <a:gridCol w="704680">
                  <a:extLst>
                    <a:ext uri="{9D8B030D-6E8A-4147-A177-3AD203B41FA5}">
                      <a16:colId xmlns:a16="http://schemas.microsoft.com/office/drawing/2014/main" val="2902290748"/>
                    </a:ext>
                  </a:extLst>
                </a:gridCol>
              </a:tblGrid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5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698210536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77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154793654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19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771328432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07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678771508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9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691166253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4042787523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433,4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-7-O-Glucosid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20845329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433,4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9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-7-O-Glucosid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27443380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433,4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-7-O-Glucosid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936455851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9,5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71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-7-O-Neohesperidosid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8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773232922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9,5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459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Naringenin-7-O-Neohesperidosid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8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854345370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623,5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314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Isorhamentin-3-O-Neohesperidosid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8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646354499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79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67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heobrom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825297808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79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09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heobrom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76627003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79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heobrom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632464018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79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69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heobrom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828500314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79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38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heobrom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595444176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93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09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Caffe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56181460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93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2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Caffe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136585101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93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5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Caffe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032390580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93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6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Caffe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3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672931612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35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4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etramethyl Pyraz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995195098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35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etramethyl Pyraz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456091210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35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21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etramethyl Pyraz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018348464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35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96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etramethyl Pyraz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685441908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2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4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rimethyl Pyraz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451494527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2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4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rimethyl Pyraz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942810960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21,2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39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Trimethyl Pyrazine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656816781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65,8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89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C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915448583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65,8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393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C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047154259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65,8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713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C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098397908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65,8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49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C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348729044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865,8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7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C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333834727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7,5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427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B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1209822782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7,5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29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B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210435437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7,5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6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cynadin B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3698958362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5,5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09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anthocyanidin A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033305507"/>
                  </a:ext>
                </a:extLst>
              </a:tr>
              <a:tr h="16098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5,5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139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anthocyanidin A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2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445314572"/>
                  </a:ext>
                </a:extLst>
              </a:tr>
              <a:tr h="167687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75,5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59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50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Proanthocyanidin A2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-45,00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 dirty="0">
                          <a:effectLst/>
                        </a:rPr>
                        <a:t>-22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07" marR="6707" marT="6707" marB="0" anchor="ctr"/>
                </a:tc>
                <a:extLst>
                  <a:ext uri="{0D108BD9-81ED-4DB2-BD59-A6C34878D82A}">
                    <a16:rowId xmlns:a16="http://schemas.microsoft.com/office/drawing/2014/main" val="29076846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001165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35</TotalTime>
  <Words>2043</Words>
  <Application>Microsoft Office PowerPoint</Application>
  <PresentationFormat>A4 (21x29,7 cm)</PresentationFormat>
  <Paragraphs>1320</Paragraphs>
  <Slides>5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TONIETTA ROSSI</dc:creator>
  <cp:lastModifiedBy>DANILO D'AVINO</cp:lastModifiedBy>
  <cp:revision>7</cp:revision>
  <dcterms:created xsi:type="dcterms:W3CDTF">2022-10-07T09:13:44Z</dcterms:created>
  <dcterms:modified xsi:type="dcterms:W3CDTF">2023-06-29T09:30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ad0b24d-6422-44b0-b3de-abb3a9e8c81a_Enabled">
    <vt:lpwstr>true</vt:lpwstr>
  </property>
  <property fmtid="{D5CDD505-2E9C-101B-9397-08002B2CF9AE}" pid="3" name="MSIP_Label_2ad0b24d-6422-44b0-b3de-abb3a9e8c81a_SetDate">
    <vt:lpwstr>2023-03-27T10:32:59Z</vt:lpwstr>
  </property>
  <property fmtid="{D5CDD505-2E9C-101B-9397-08002B2CF9AE}" pid="4" name="MSIP_Label_2ad0b24d-6422-44b0-b3de-abb3a9e8c81a_Method">
    <vt:lpwstr>Standard</vt:lpwstr>
  </property>
  <property fmtid="{D5CDD505-2E9C-101B-9397-08002B2CF9AE}" pid="5" name="MSIP_Label_2ad0b24d-6422-44b0-b3de-abb3a9e8c81a_Name">
    <vt:lpwstr>defa4170-0d19-0005-0004-bc88714345d2</vt:lpwstr>
  </property>
  <property fmtid="{D5CDD505-2E9C-101B-9397-08002B2CF9AE}" pid="6" name="MSIP_Label_2ad0b24d-6422-44b0-b3de-abb3a9e8c81a_SiteId">
    <vt:lpwstr>2fcfe26a-bb62-46b0-b1e3-28f9da0c45fd</vt:lpwstr>
  </property>
  <property fmtid="{D5CDD505-2E9C-101B-9397-08002B2CF9AE}" pid="7" name="MSIP_Label_2ad0b24d-6422-44b0-b3de-abb3a9e8c81a_ActionId">
    <vt:lpwstr>4d0202f9-ea2b-4afe-bb69-a2d1c75f2ba3</vt:lpwstr>
  </property>
  <property fmtid="{D5CDD505-2E9C-101B-9397-08002B2CF9AE}" pid="8" name="MSIP_Label_2ad0b24d-6422-44b0-b3de-abb3a9e8c81a_ContentBits">
    <vt:lpwstr>0</vt:lpwstr>
  </property>
</Properties>
</file>